
<file path=[Content_Types].xml><?xml version="1.0" encoding="utf-8"?>
<Types xmlns="http://schemas.openxmlformats.org/package/2006/content-types">
  <Override PartName="/ppt/charts/chart1.xml" ContentType="application/vnd.openxmlformats-officedocument.drawingml.chart+xml"/>
  <Override PartName="/ppt/slideLayouts/slideLayout1.xml" ContentType="application/vnd.openxmlformats-officedocument.presentationml.slideLayout+xml"/>
  <Default Extension="png" ContentType="image/png"/>
  <Default Extension="rels" ContentType="application/vnd.openxmlformats-package.relationships+xml"/>
  <Default Extension="jpeg" ContentType="image/jpeg"/>
  <Default Extension="xml" ContentType="application/xml"/>
  <Override PartName="/ppt/tableStyles.xml" ContentType="application/vnd.openxmlformats-officedocument.presentationml.tableStyles+xml"/>
  <Override PartName="/ppt/charts/chart8.xml" ContentType="application/vnd.openxmlformats-officedocument.drawingml.chart+xml"/>
  <Override PartName="/ppt/slideLayouts/slideLayout8.xml" ContentType="application/vnd.openxmlformats-officedocument.presentationml.slideLayou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charts/chart4.xml" ContentType="application/vnd.openxmlformats-officedocument.drawingml.char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hart2.xml" ContentType="application/vnd.openxmlformats-officedocument.drawingml.char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tiff" ContentType="image/tiff"/>
  <Override PartName="/ppt/charts/chart9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presentation.xml" ContentType="application/vnd.openxmlformats-officedocument.presentationml.presentation.main+xml"/>
  <Override PartName="/ppt/drawings/drawing2.xml" ContentType="application/vnd.openxmlformats-officedocument.drawingml.chartshapes+xml"/>
  <Override PartName="/ppt/charts/chart7.xml" ContentType="application/vnd.openxmlformats-officedocument.drawingml.chart+xml"/>
  <Override PartName="/ppt/slideLayouts/slideLayout7.xml" ContentType="application/vnd.openxmlformats-officedocument.presentationml.slideLayout+xml"/>
  <Override PartName="/ppt/charts/chart5.xml" ContentType="application/vnd.openxmlformats-officedocument.drawingml.chart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charts/chart3.xml" ContentType="application/vnd.openxmlformats-officedocument.drawingml.chart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3336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orjan:Documents:&#214;W%20dokuments:Image%20Gauge%20+data&#214;W:Gauge%20files%202014:141111_ARvsGR_no%20Fox:141111_cpm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orjan:Documents:&#214;W%20dokuments:Image%20Gauge%20+data&#214;W:Gauge%20files%202014:141111_ARvsGR_no%20Fox:141111_cpm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Workbook2" TargetMode="External"/><Relationship Id="rId2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Workbook3" TargetMode="External"/><Relationship Id="rId2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Workbook8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Workbook8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Workbook8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ergey:Desktop:sergej:Documents:Belikov%20ImageG%20files:%20&#9734;Sergey's%20IG%20files%202013:20130425:20120425-DMS_S1%20(version%201).xlsb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ergey:Desktop:sergej:Documents:Belikov%20ImageG%20files:%20&#9734;Sergey's%20IG%20files%202013:20130425:20120425-S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8"/>
  <c:chart>
    <c:title>
      <c:tx>
        <c:rich>
          <a:bodyPr/>
          <a:lstStyle/>
          <a:p>
            <a:pPr>
              <a:defRPr sz="1400" b="0"/>
            </a:pPr>
            <a:r>
              <a:rPr lang="en-US" sz="1400" b="0"/>
              <a:t> [3H]-R1881 amount (pmol)</a:t>
            </a:r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Sheet1!$U$13:$U$16</c:f>
                <c:numCache>
                  <c:formatCode>General</c:formatCode>
                  <c:ptCount val="4"/>
                  <c:pt idx="0">
                    <c:v>0.015</c:v>
                  </c:pt>
                  <c:pt idx="1">
                    <c:v>0.0749999999999999</c:v>
                  </c:pt>
                  <c:pt idx="2">
                    <c:v>0.00047167757287329</c:v>
                  </c:pt>
                  <c:pt idx="3">
                    <c:v>0.00151538964901844</c:v>
                  </c:pt>
                </c:numCache>
              </c:numRef>
            </c:plus>
            <c:minus>
              <c:numRef>
                <c:f>Sheet1!$U$13:$U$16</c:f>
                <c:numCache>
                  <c:formatCode>General</c:formatCode>
                  <c:ptCount val="4"/>
                  <c:pt idx="0">
                    <c:v>0.015</c:v>
                  </c:pt>
                  <c:pt idx="1">
                    <c:v>0.0749999999999999</c:v>
                  </c:pt>
                  <c:pt idx="2">
                    <c:v>0.00047167757287329</c:v>
                  </c:pt>
                  <c:pt idx="3">
                    <c:v>0.00151538964901844</c:v>
                  </c:pt>
                </c:numCache>
              </c:numRef>
            </c:minus>
            <c:spPr>
              <a:ln w="12700" cmpd="sng"/>
            </c:spPr>
          </c:errBars>
          <c:cat>
            <c:strRef>
              <c:f>Sheet1!$S$13:$S$16</c:f>
              <c:strCache>
                <c:ptCount val="4"/>
                <c:pt idx="0">
                  <c:v>ooc.extr ctr.</c:v>
                </c:pt>
                <c:pt idx="1">
                  <c:v>ooc.extr AR</c:v>
                </c:pt>
                <c:pt idx="2">
                  <c:v>nucl.extr ctr.</c:v>
                </c:pt>
                <c:pt idx="3">
                  <c:v>nucl. extr AR</c:v>
                </c:pt>
              </c:strCache>
            </c:strRef>
          </c:cat>
          <c:val>
            <c:numRef>
              <c:f>Sheet1!$T$13:$T$16</c:f>
              <c:numCache>
                <c:formatCode>General</c:formatCode>
                <c:ptCount val="4"/>
                <c:pt idx="0">
                  <c:v>1.475</c:v>
                </c:pt>
                <c:pt idx="1">
                  <c:v>1.155</c:v>
                </c:pt>
                <c:pt idx="2">
                  <c:v>0.00508809637120761</c:v>
                </c:pt>
                <c:pt idx="3">
                  <c:v>0.0258419095776324</c:v>
                </c:pt>
              </c:numCache>
            </c:numRef>
          </c:val>
        </c:ser>
        <c:axId val="445789688"/>
        <c:axId val="477454872"/>
      </c:barChart>
      <c:catAx>
        <c:axId val="445789688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477454872"/>
        <c:crosses val="autoZero"/>
        <c:auto val="1"/>
        <c:lblAlgn val="ctr"/>
        <c:lblOffset val="100"/>
      </c:catAx>
      <c:valAx>
        <c:axId val="477454872"/>
        <c:scaling>
          <c:orientation val="minMax"/>
        </c:scaling>
        <c:axPos val="l"/>
        <c:majorGridlines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[3H]-R1881 amount (pmol)</a:t>
                </a:r>
              </a:p>
            </c:rich>
          </c:tx>
          <c:layout/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445789688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8"/>
  <c:chart>
    <c:autoTitleDeleted val="1"/>
    <c:plotArea>
      <c:layout>
        <c:manualLayout>
          <c:layoutTarget val="inner"/>
          <c:xMode val="edge"/>
          <c:yMode val="edge"/>
          <c:x val="0.249818695201522"/>
          <c:y val="0.0657370621038777"/>
          <c:w val="0.750181304798478"/>
          <c:h val="0.868525875792244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Sheet1!$U$15:$U$16</c:f>
                <c:numCache>
                  <c:formatCode>General</c:formatCode>
                  <c:ptCount val="2"/>
                  <c:pt idx="0">
                    <c:v>0.00047167757287329</c:v>
                  </c:pt>
                  <c:pt idx="1">
                    <c:v>0.00151538964901844</c:v>
                  </c:pt>
                </c:numCache>
              </c:numRef>
            </c:plus>
            <c:minus>
              <c:numRef>
                <c:f>Sheet1!$U$15:$U$16</c:f>
                <c:numCache>
                  <c:formatCode>General</c:formatCode>
                  <c:ptCount val="2"/>
                  <c:pt idx="0">
                    <c:v>0.00047167757287329</c:v>
                  </c:pt>
                  <c:pt idx="1">
                    <c:v>0.00151538964901844</c:v>
                  </c:pt>
                </c:numCache>
              </c:numRef>
            </c:minus>
            <c:spPr>
              <a:ln w="12700" cmpd="sng"/>
            </c:spPr>
          </c:errBars>
          <c:cat>
            <c:strRef>
              <c:f>Sheet1!$S$15:$S$16</c:f>
              <c:strCache>
                <c:ptCount val="2"/>
                <c:pt idx="0">
                  <c:v>nucl.extr ctr.</c:v>
                </c:pt>
                <c:pt idx="1">
                  <c:v>nucl. extr AR</c:v>
                </c:pt>
              </c:strCache>
            </c:strRef>
          </c:cat>
          <c:val>
            <c:numRef>
              <c:f>Sheet1!$T$15:$T$16</c:f>
              <c:numCache>
                <c:formatCode>General</c:formatCode>
                <c:ptCount val="2"/>
                <c:pt idx="0">
                  <c:v>0.00508809637120761</c:v>
                </c:pt>
                <c:pt idx="1">
                  <c:v>0.0258419095776324</c:v>
                </c:pt>
              </c:numCache>
            </c:numRef>
          </c:val>
        </c:ser>
        <c:axId val="491837208"/>
        <c:axId val="477115544"/>
      </c:barChart>
      <c:catAx>
        <c:axId val="491837208"/>
        <c:scaling>
          <c:orientation val="minMax"/>
        </c:scaling>
        <c:delete val="1"/>
        <c:axPos val="b"/>
        <c:tickLblPos val="nextTo"/>
        <c:crossAx val="477115544"/>
        <c:crosses val="autoZero"/>
        <c:auto val="1"/>
        <c:lblAlgn val="ctr"/>
        <c:lblOffset val="100"/>
      </c:catAx>
      <c:valAx>
        <c:axId val="477115544"/>
        <c:scaling>
          <c:orientation val="minMax"/>
        </c:scaling>
        <c:axPos val="l"/>
        <c:majorGridlines/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 Narrow"/>
                <a:cs typeface="Arial Narrow"/>
              </a:defRPr>
            </a:pPr>
            <a:endParaRPr lang="en-US"/>
          </a:p>
        </c:txPr>
        <c:crossAx val="491837208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8"/>
  <c:chart>
    <c:autoTitleDeleted val="1"/>
    <c:plotArea>
      <c:layout>
        <c:manualLayout>
          <c:layoutTarget val="inner"/>
          <c:xMode val="edge"/>
          <c:yMode val="edge"/>
          <c:x val="0.20501930919204"/>
          <c:y val="0.186143096636286"/>
          <c:w val="0.735504056371313"/>
          <c:h val="0.622697817828184"/>
        </c:manualLayout>
      </c:layout>
      <c:barChart>
        <c:barDir val="col"/>
        <c:grouping val="clustered"/>
        <c:ser>
          <c:idx val="0"/>
          <c:order val="0"/>
          <c:tx>
            <c:strRef>
              <c:f>'[20140318.xlsx]Sheet1'!$A$26</c:f>
              <c:strCache>
                <c:ptCount val="1"/>
                <c:pt idx="0">
                  <c:v>MMTV trx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effectLst/>
          </c:spPr>
          <c:errBars>
            <c:errBarType val="both"/>
            <c:errValType val="cust"/>
            <c:plus>
              <c:numRef>
                <c:f>'[20140318.xlsx]Sheet1'!$B$27:$B$35</c:f>
                <c:numCache>
                  <c:formatCode>General</c:formatCode>
                  <c:ptCount val="9"/>
                  <c:pt idx="0">
                    <c:v>12.84249999999997</c:v>
                  </c:pt>
                  <c:pt idx="1">
                    <c:v>61.93749999999994</c:v>
                  </c:pt>
                  <c:pt idx="2">
                    <c:v>4.077500000000015</c:v>
                  </c:pt>
                  <c:pt idx="3">
                    <c:v>20.5824999999999</c:v>
                  </c:pt>
                  <c:pt idx="4">
                    <c:v>1609.685</c:v>
                  </c:pt>
                  <c:pt idx="5">
                    <c:v>2.29499999999996</c:v>
                  </c:pt>
                  <c:pt idx="6">
                    <c:v>14.33750000000001</c:v>
                  </c:pt>
                  <c:pt idx="7">
                    <c:v>198.9475000000001</c:v>
                  </c:pt>
                  <c:pt idx="8">
                    <c:v>941.0699999999994</c:v>
                  </c:pt>
                </c:numCache>
              </c:numRef>
            </c:plus>
            <c:minus>
              <c:numRef>
                <c:f>'[20140318.xlsx]Sheet1'!$B$27:$B$35</c:f>
                <c:numCache>
                  <c:formatCode>General</c:formatCode>
                  <c:ptCount val="9"/>
                  <c:pt idx="0">
                    <c:v>12.84249999999997</c:v>
                  </c:pt>
                  <c:pt idx="1">
                    <c:v>61.93749999999994</c:v>
                  </c:pt>
                  <c:pt idx="2">
                    <c:v>4.077500000000015</c:v>
                  </c:pt>
                  <c:pt idx="3">
                    <c:v>20.5824999999999</c:v>
                  </c:pt>
                  <c:pt idx="4">
                    <c:v>1609.685</c:v>
                  </c:pt>
                  <c:pt idx="5">
                    <c:v>2.29499999999996</c:v>
                  </c:pt>
                  <c:pt idx="6">
                    <c:v>14.33750000000001</c:v>
                  </c:pt>
                  <c:pt idx="7">
                    <c:v>198.9475000000001</c:v>
                  </c:pt>
                  <c:pt idx="8">
                    <c:v>941.0699999999994</c:v>
                  </c:pt>
                </c:numCache>
              </c:numRef>
            </c:minus>
          </c:errBars>
          <c:val>
            <c:numRef>
              <c:f>'[20140318.xlsx]Sheet1'!$A$27:$A$35</c:f>
              <c:numCache>
                <c:formatCode>General</c:formatCode>
                <c:ptCount val="9"/>
                <c:pt idx="0">
                  <c:v>35.8075</c:v>
                </c:pt>
                <c:pt idx="1">
                  <c:v>314.6425</c:v>
                </c:pt>
                <c:pt idx="2">
                  <c:v>500.3824999999999</c:v>
                </c:pt>
                <c:pt idx="3">
                  <c:v>1960.9825</c:v>
                </c:pt>
                <c:pt idx="4">
                  <c:v>8289.24</c:v>
                </c:pt>
                <c:pt idx="5">
                  <c:v>454.285</c:v>
                </c:pt>
                <c:pt idx="6">
                  <c:v>462.5775000000001</c:v>
                </c:pt>
                <c:pt idx="7">
                  <c:v>1036.3325</c:v>
                </c:pt>
                <c:pt idx="8">
                  <c:v>4205.934999999999</c:v>
                </c:pt>
              </c:numCache>
            </c:numRef>
          </c:val>
        </c:ser>
        <c:axId val="73754360"/>
        <c:axId val="476248696"/>
      </c:barChart>
      <c:catAx>
        <c:axId val="73754360"/>
        <c:scaling>
          <c:orientation val="minMax"/>
        </c:scaling>
        <c:axPos val="b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76248696"/>
        <c:crosses val="autoZero"/>
        <c:auto val="1"/>
        <c:lblAlgn val="ctr"/>
        <c:lblOffset val="100"/>
      </c:catAx>
      <c:valAx>
        <c:axId val="476248696"/>
        <c:scaling>
          <c:orientation val="minMax"/>
        </c:scaling>
        <c:axPos val="l"/>
        <c:majorGridlines>
          <c:spPr>
            <a:ln w="6350">
              <a:prstDash val="sysDash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MTV trx. (A.U.)</a:t>
                </a:r>
              </a:p>
            </c:rich>
          </c:tx>
          <c:layout/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73754360"/>
        <c:crosses val="autoZero"/>
        <c:crossBetween val="between"/>
      </c:valAx>
    </c:plotArea>
    <c:plotVisOnly val="1"/>
  </c:chart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autoTitleDeleted val="1"/>
    <c:plotArea>
      <c:layout>
        <c:manualLayout>
          <c:layoutTarget val="inner"/>
          <c:xMode val="edge"/>
          <c:yMode val="edge"/>
          <c:x val="0.158880378339736"/>
          <c:y val="0.252595155709343"/>
          <c:w val="0.341941190796037"/>
          <c:h val="0.611978039942239"/>
        </c:manualLayout>
      </c:layout>
      <c:scatterChart>
        <c:scatterStyle val="lineMarker"/>
        <c:ser>
          <c:idx val="0"/>
          <c:order val="0"/>
          <c:tx>
            <c:v>Q25</c:v>
          </c:tx>
          <c:spPr>
            <a:ln>
              <a:noFill/>
            </a:ln>
          </c:spPr>
          <c:marker>
            <c:symbol val="diamond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x"/>
            <c:errBarType val="both"/>
            <c:errValType val="cust"/>
            <c:plus>
              <c:numRef>
                <c:f>'[20140318.xlsx]Sheet1'!$P$3:$P$7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690977787955118</c:v>
                  </c:pt>
                  <c:pt idx="2">
                    <c:v>0.0381984199679414</c:v>
                  </c:pt>
                  <c:pt idx="3">
                    <c:v>0.187829173345546</c:v>
                  </c:pt>
                  <c:pt idx="4">
                    <c:v>0.059852301351042</c:v>
                  </c:pt>
                </c:numCache>
              </c:numRef>
            </c:plus>
            <c:minus>
              <c:numRef>
                <c:f>'[20140318.xlsx]Sheet1'!$P$3:$P$7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690977787955118</c:v>
                  </c:pt>
                  <c:pt idx="2">
                    <c:v>0.0381984199679414</c:v>
                  </c:pt>
                  <c:pt idx="3">
                    <c:v>0.187829173345546</c:v>
                  </c:pt>
                  <c:pt idx="4">
                    <c:v>0.059852301351042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plus>
              <c:numRef>
                <c:f>'[20140318.xlsx]Sheet1'!$D$27:$D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61.93749999999994</c:v>
                  </c:pt>
                  <c:pt idx="2">
                    <c:v>4.077500000000015</c:v>
                  </c:pt>
                  <c:pt idx="3">
                    <c:v>20.5824999999999</c:v>
                  </c:pt>
                  <c:pt idx="4">
                    <c:v>1609.685</c:v>
                  </c:pt>
                </c:numCache>
              </c:numRef>
            </c:plus>
            <c:minus>
              <c:numRef>
                <c:f>'[20140318.xlsx]Sheet1'!$D$27:$D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61.93749999999994</c:v>
                  </c:pt>
                  <c:pt idx="2">
                    <c:v>4.077500000000015</c:v>
                  </c:pt>
                  <c:pt idx="3">
                    <c:v>20.5824999999999</c:v>
                  </c:pt>
                  <c:pt idx="4">
                    <c:v>1609.685</c:v>
                  </c:pt>
                </c:numCache>
              </c:numRef>
            </c:minus>
          </c:errBars>
          <c:xVal>
            <c:numRef>
              <c:f>'[20140318.xlsx]Sheet1'!$O$3:$O$7</c:f>
              <c:numCache>
                <c:formatCode>General</c:formatCode>
                <c:ptCount val="5"/>
                <c:pt idx="0">
                  <c:v>0.0</c:v>
                </c:pt>
                <c:pt idx="1">
                  <c:v>0.487777650561026</c:v>
                </c:pt>
                <c:pt idx="2">
                  <c:v>0.53862777650561</c:v>
                </c:pt>
                <c:pt idx="3">
                  <c:v>1.199192809709182</c:v>
                </c:pt>
                <c:pt idx="4">
                  <c:v>1.406486146095718</c:v>
                </c:pt>
              </c:numCache>
            </c:numRef>
          </c:xVal>
          <c:yVal>
            <c:numRef>
              <c:f>'[20140318.xlsx]Sheet1'!$C$27:$C$31</c:f>
              <c:numCache>
                <c:formatCode>General</c:formatCode>
                <c:ptCount val="5"/>
                <c:pt idx="0">
                  <c:v>35.8075</c:v>
                </c:pt>
                <c:pt idx="1">
                  <c:v>314.6425</c:v>
                </c:pt>
                <c:pt idx="2">
                  <c:v>500.3824999999999</c:v>
                </c:pt>
                <c:pt idx="3">
                  <c:v>1960.9825</c:v>
                </c:pt>
                <c:pt idx="4">
                  <c:v>8289.24</c:v>
                </c:pt>
              </c:numCache>
            </c:numRef>
          </c:yVal>
          <c:smooth val="1"/>
        </c:ser>
        <c:ser>
          <c:idx val="1"/>
          <c:order val="1"/>
          <c:tx>
            <c:v>Q64</c:v>
          </c:tx>
          <c:spPr>
            <a:ln w="19050">
              <a:noFill/>
              <a:prstDash val="sysDot"/>
            </a:ln>
          </c:spPr>
          <c:marker>
            <c:symbol val="diamond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x"/>
            <c:errBarType val="both"/>
            <c:errValType val="cust"/>
            <c:plus>
              <c:numRef>
                <c:f>'[20140318.xlsx]Sheet1'!$P$15:$P$19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313859629035952</c:v>
                  </c:pt>
                  <c:pt idx="2">
                    <c:v>1.11022302462516E-16</c:v>
                  </c:pt>
                  <c:pt idx="3">
                    <c:v>0.14500801465537</c:v>
                  </c:pt>
                  <c:pt idx="4">
                    <c:v>0.223594572933364</c:v>
                  </c:pt>
                </c:numCache>
              </c:numRef>
            </c:plus>
            <c:minus>
              <c:numRef>
                <c:f>'[20140318.xlsx]Sheet1'!$P$15:$P$19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313859629035952</c:v>
                  </c:pt>
                  <c:pt idx="2">
                    <c:v>1.11022302462516E-16</c:v>
                  </c:pt>
                  <c:pt idx="3">
                    <c:v>0.14500801465537</c:v>
                  </c:pt>
                  <c:pt idx="4">
                    <c:v>0.223594572933364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plus>
              <c:numRef>
                <c:f>'[20140318.xlsx]Sheet1'!$F$27:$F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2.29499999999996</c:v>
                  </c:pt>
                  <c:pt idx="2">
                    <c:v>14.33750000000001</c:v>
                  </c:pt>
                  <c:pt idx="3">
                    <c:v>198.9475000000001</c:v>
                  </c:pt>
                  <c:pt idx="4">
                    <c:v>941.0699999999994</c:v>
                  </c:pt>
                </c:numCache>
              </c:numRef>
            </c:plus>
            <c:minus>
              <c:numRef>
                <c:f>'[20140318.xlsx]Sheet1'!$F$27:$F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2.29499999999996</c:v>
                  </c:pt>
                  <c:pt idx="2">
                    <c:v>14.33750000000001</c:v>
                  </c:pt>
                  <c:pt idx="3">
                    <c:v>198.9475000000001</c:v>
                  </c:pt>
                  <c:pt idx="4">
                    <c:v>941.0699999999994</c:v>
                  </c:pt>
                </c:numCache>
              </c:numRef>
            </c:minus>
          </c:errBars>
          <c:xVal>
            <c:numRef>
              <c:f>'[20140318.xlsx]Sheet1'!$O$15:$O$19</c:f>
              <c:numCache>
                <c:formatCode>General</c:formatCode>
                <c:ptCount val="5"/>
                <c:pt idx="0">
                  <c:v>0.0</c:v>
                </c:pt>
                <c:pt idx="1">
                  <c:v>0.48510132814289</c:v>
                </c:pt>
                <c:pt idx="2">
                  <c:v>0.586558277994046</c:v>
                </c:pt>
                <c:pt idx="3">
                  <c:v>1.090193496679643</c:v>
                </c:pt>
                <c:pt idx="4">
                  <c:v>1.740053240210671</c:v>
                </c:pt>
              </c:numCache>
            </c:numRef>
          </c:xVal>
          <c:yVal>
            <c:numRef>
              <c:f>'[20140318.xlsx]Sheet1'!$E$27:$E$31</c:f>
              <c:numCache>
                <c:formatCode>General</c:formatCode>
                <c:ptCount val="5"/>
                <c:pt idx="0">
                  <c:v>35.8075</c:v>
                </c:pt>
                <c:pt idx="1">
                  <c:v>454.285</c:v>
                </c:pt>
                <c:pt idx="2">
                  <c:v>462.5775000000001</c:v>
                </c:pt>
                <c:pt idx="3">
                  <c:v>1036.3325</c:v>
                </c:pt>
                <c:pt idx="4">
                  <c:v>4205.934999999999</c:v>
                </c:pt>
              </c:numCache>
            </c:numRef>
          </c:yVal>
          <c:smooth val="1"/>
        </c:ser>
        <c:ser>
          <c:idx val="2"/>
          <c:order val="2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[20140318.xlsx]Sheet1'!$E$88:$E$114</c:f>
              <c:numCache>
                <c:formatCode>General</c:formatCode>
                <c:ptCount val="27"/>
                <c:pt idx="0">
                  <c:v>0.0</c:v>
                </c:pt>
                <c:pt idx="1">
                  <c:v>0.0749999999999999</c:v>
                </c:pt>
                <c:pt idx="2">
                  <c:v>0.149999999999999</c:v>
                </c:pt>
                <c:pt idx="3">
                  <c:v>0.224999999999999</c:v>
                </c:pt>
                <c:pt idx="4">
                  <c:v>0.299999999999999</c:v>
                </c:pt>
                <c:pt idx="5">
                  <c:v>0.375</c:v>
                </c:pt>
                <c:pt idx="6">
                  <c:v>0.449999999999999</c:v>
                </c:pt>
                <c:pt idx="7">
                  <c:v>0.525</c:v>
                </c:pt>
                <c:pt idx="8">
                  <c:v>0.599999999999999</c:v>
                </c:pt>
                <c:pt idx="9">
                  <c:v>0.674999999999999</c:v>
                </c:pt>
                <c:pt idx="10">
                  <c:v>0.75</c:v>
                </c:pt>
                <c:pt idx="11">
                  <c:v>0.824999999999999</c:v>
                </c:pt>
                <c:pt idx="12">
                  <c:v>0.899999999999999</c:v>
                </c:pt>
                <c:pt idx="13">
                  <c:v>0.974999999999999</c:v>
                </c:pt>
                <c:pt idx="14">
                  <c:v>1.05</c:v>
                </c:pt>
                <c:pt idx="15">
                  <c:v>1.125</c:v>
                </c:pt>
                <c:pt idx="16">
                  <c:v>1.15</c:v>
                </c:pt>
                <c:pt idx="17">
                  <c:v>1.175</c:v>
                </c:pt>
                <c:pt idx="18">
                  <c:v>1.2</c:v>
                </c:pt>
                <c:pt idx="19">
                  <c:v>1.225</c:v>
                </c:pt>
                <c:pt idx="20">
                  <c:v>1.25</c:v>
                </c:pt>
                <c:pt idx="21">
                  <c:v>1.275</c:v>
                </c:pt>
                <c:pt idx="22">
                  <c:v>1.3</c:v>
                </c:pt>
                <c:pt idx="23">
                  <c:v>1.325</c:v>
                </c:pt>
                <c:pt idx="24">
                  <c:v>1.35</c:v>
                </c:pt>
                <c:pt idx="25">
                  <c:v>1.375</c:v>
                </c:pt>
                <c:pt idx="26">
                  <c:v>1.4</c:v>
                </c:pt>
              </c:numCache>
            </c:numRef>
          </c:xVal>
          <c:yVal>
            <c:numRef>
              <c:f>'[20140318.xlsx]Sheet1'!$F$88:$F$114</c:f>
              <c:numCache>
                <c:formatCode>General</c:formatCode>
                <c:ptCount val="27"/>
                <c:pt idx="0">
                  <c:v>34.0450351124211</c:v>
                </c:pt>
                <c:pt idx="1">
                  <c:v>94.8931233968289</c:v>
                </c:pt>
                <c:pt idx="2">
                  <c:v>149.981809739045</c:v>
                </c:pt>
                <c:pt idx="3">
                  <c:v>201.977801359553</c:v>
                </c:pt>
                <c:pt idx="4">
                  <c:v>252.900052768815</c:v>
                </c:pt>
                <c:pt idx="5">
                  <c:v>304.450706933695</c:v>
                </c:pt>
                <c:pt idx="6">
                  <c:v>358.2350143786002</c:v>
                </c:pt>
                <c:pt idx="7">
                  <c:v>415.939143699154</c:v>
                </c:pt>
                <c:pt idx="8">
                  <c:v>479.5107177417086</c:v>
                </c:pt>
                <c:pt idx="9">
                  <c:v>551.3841623754004</c:v>
                </c:pt>
                <c:pt idx="10">
                  <c:v>634.807878777897</c:v>
                </c:pt>
                <c:pt idx="11">
                  <c:v>734.371278594362</c:v>
                </c:pt>
                <c:pt idx="12">
                  <c:v>856.924882598512</c:v>
                </c:pt>
                <c:pt idx="13">
                  <c:v>1013.31393285988</c:v>
                </c:pt>
                <c:pt idx="14">
                  <c:v>1221.93660801648</c:v>
                </c:pt>
                <c:pt idx="15">
                  <c:v>1516.86994508201</c:v>
                </c:pt>
                <c:pt idx="16">
                  <c:v>1644.77209476572</c:v>
                </c:pt>
                <c:pt idx="17">
                  <c:v>1793.66524180302</c:v>
                </c:pt>
                <c:pt idx="18">
                  <c:v>1969.29450771366</c:v>
                </c:pt>
                <c:pt idx="19">
                  <c:v>2179.70417638671</c:v>
                </c:pt>
                <c:pt idx="20">
                  <c:v>2436.51635145832</c:v>
                </c:pt>
                <c:pt idx="21">
                  <c:v>2757.16967592049</c:v>
                </c:pt>
                <c:pt idx="22">
                  <c:v>3169.07940778968</c:v>
                </c:pt>
                <c:pt idx="23">
                  <c:v>3717.96378830411</c:v>
                </c:pt>
                <c:pt idx="24">
                  <c:v>4486.17998801525</c:v>
                </c:pt>
                <c:pt idx="25">
                  <c:v>5638.62573322473</c:v>
                </c:pt>
                <c:pt idx="26">
                  <c:v>7560.71928399604</c:v>
                </c:pt>
              </c:numCache>
            </c:numRef>
          </c:yVal>
          <c:smooth val="1"/>
        </c:ser>
        <c:axId val="485001768"/>
        <c:axId val="485144152"/>
      </c:scatterChart>
      <c:valAx>
        <c:axId val="485001768"/>
        <c:scaling>
          <c:orientation val="minMax"/>
          <c:max val="2.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Nuclear [AR] (</a:t>
                </a:r>
                <a:r>
                  <a:rPr lang="en-US" dirty="0" err="1">
                    <a:latin typeface="Symbol" charset="2"/>
                    <a:cs typeface="Symbol" charset="2"/>
                  </a:rPr>
                  <a:t>m</a:t>
                </a:r>
                <a:r>
                  <a:rPr lang="en-US" dirty="0" err="1"/>
                  <a:t>M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0.167113038423165"/>
              <c:y val="0.927335640138408"/>
            </c:manualLayout>
          </c:layout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85144152"/>
        <c:crosses val="autoZero"/>
        <c:crossBetween val="midCat"/>
      </c:valAx>
      <c:valAx>
        <c:axId val="485144152"/>
        <c:scaling>
          <c:orientation val="minMax"/>
          <c:max val="10000.0"/>
        </c:scaling>
        <c:axPos val="l"/>
        <c:majorGridlines>
          <c:spPr>
            <a:ln w="6350">
              <a:prstDash val="sysDash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MMTV </a:t>
                </a:r>
                <a:r>
                  <a:rPr lang="en-US" dirty="0" err="1"/>
                  <a:t>trx</a:t>
                </a:r>
                <a:r>
                  <a:rPr lang="en-US" dirty="0"/>
                  <a:t>. (A.U.)</a:t>
                </a:r>
              </a:p>
            </c:rich>
          </c:tx>
          <c:layout/>
        </c:title>
        <c:numFmt formatCode="General" sourceLinked="1"/>
        <c:tickLblPos val="nextTo"/>
        <c:spPr>
          <a:ln w="6350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85001768"/>
        <c:crosses val="autoZero"/>
        <c:crossBetween val="midCat"/>
      </c:valAx>
    </c:plotArea>
    <c:legend>
      <c:legendPos val="r"/>
      <c:legendEntry>
        <c:idx val="2"/>
        <c:delete val="1"/>
      </c:legendEntry>
      <c:layout>
        <c:manualLayout>
          <c:xMode val="edge"/>
          <c:yMode val="edge"/>
          <c:x val="0.523100249031761"/>
          <c:y val="0.478951856796447"/>
          <c:w val="0.217498212784678"/>
          <c:h val="0.125141269106068"/>
        </c:manualLayout>
      </c:layout>
      <c:txPr>
        <a:bodyPr/>
        <a:lstStyle/>
        <a:p>
          <a:pPr>
            <a:defRPr sz="1000"/>
          </a:pPr>
          <a:endParaRPr lang="en-US"/>
        </a:p>
      </c:txPr>
    </c:legend>
    <c:plotVisOnly val="1"/>
  </c:chart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autoTitleDeleted val="1"/>
    <c:plotArea>
      <c:layout>
        <c:manualLayout>
          <c:layoutTarget val="inner"/>
          <c:xMode val="edge"/>
          <c:yMode val="edge"/>
          <c:x val="0.241252398673143"/>
          <c:y val="0.0513067238618501"/>
          <c:w val="0.565527080211505"/>
          <c:h val="0.702950505788292"/>
        </c:manualLayout>
      </c:layout>
      <c:scatterChart>
        <c:scatterStyle val="lineMarker"/>
        <c:ser>
          <c:idx val="0"/>
          <c:order val="0"/>
          <c:tx>
            <c:v>Q25</c:v>
          </c:tx>
          <c:spPr>
            <a:ln w="19050">
              <a:noFill/>
              <a:prstDash val="sysDash"/>
            </a:ln>
          </c:spPr>
          <c:marker>
            <c:symbol val="diamond"/>
            <c:size val="4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[20140318.xlsx]Sheet1'!$D$27:$D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61.93749999999994</c:v>
                  </c:pt>
                  <c:pt idx="2">
                    <c:v>4.077500000000015</c:v>
                  </c:pt>
                  <c:pt idx="3">
                    <c:v>20.5824999999999</c:v>
                  </c:pt>
                  <c:pt idx="4">
                    <c:v>1609.685</c:v>
                  </c:pt>
                </c:numCache>
              </c:numRef>
            </c:plus>
            <c:minus>
              <c:numRef>
                <c:f>'[20140318.xlsx]Sheet1'!$D$27:$D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61.93749999999994</c:v>
                  </c:pt>
                  <c:pt idx="2">
                    <c:v>4.077500000000015</c:v>
                  </c:pt>
                  <c:pt idx="3">
                    <c:v>20.5824999999999</c:v>
                  </c:pt>
                  <c:pt idx="4">
                    <c:v>1609.685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plus>
              <c:numRef>
                <c:f>'[20140318.xlsx]Sheet1'!$O$25:$O$29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003449595468908</c:v>
                  </c:pt>
                  <c:pt idx="2">
                    <c:v>2.730638909289304</c:v>
                  </c:pt>
                  <c:pt idx="3">
                    <c:v>2.871340801230929</c:v>
                  </c:pt>
                  <c:pt idx="4">
                    <c:v>1.547022972313371</c:v>
                  </c:pt>
                </c:numCache>
              </c:numRef>
            </c:plus>
            <c:minus>
              <c:numRef>
                <c:f>'[20140318.xlsx]Sheet1'!$O$25:$O$29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003449595468908</c:v>
                  </c:pt>
                  <c:pt idx="2">
                    <c:v>2.730638909289304</c:v>
                  </c:pt>
                  <c:pt idx="3">
                    <c:v>2.871340801230929</c:v>
                  </c:pt>
                  <c:pt idx="4">
                    <c:v>1.547022972313371</c:v>
                  </c:pt>
                </c:numCache>
              </c:numRef>
            </c:minus>
          </c:errBars>
          <c:xVal>
            <c:numRef>
              <c:f>'[20140318.xlsx]Sheet1'!$N$25:$N$29</c:f>
              <c:numCache>
                <c:formatCode>General</c:formatCode>
                <c:ptCount val="5"/>
                <c:pt idx="0">
                  <c:v>0.0</c:v>
                </c:pt>
                <c:pt idx="1">
                  <c:v>6.614543399242649</c:v>
                </c:pt>
                <c:pt idx="2">
                  <c:v>10.27980441847973</c:v>
                </c:pt>
                <c:pt idx="3">
                  <c:v>15.8569383300288</c:v>
                </c:pt>
                <c:pt idx="4">
                  <c:v>29.91375654266962</c:v>
                </c:pt>
              </c:numCache>
            </c:numRef>
          </c:xVal>
          <c:yVal>
            <c:numRef>
              <c:f>'[20140318.xlsx]Sheet1'!$C$27:$C$31</c:f>
              <c:numCache>
                <c:formatCode>General</c:formatCode>
                <c:ptCount val="5"/>
                <c:pt idx="0">
                  <c:v>35.8075</c:v>
                </c:pt>
                <c:pt idx="1">
                  <c:v>314.6425</c:v>
                </c:pt>
                <c:pt idx="2">
                  <c:v>500.3824999999999</c:v>
                </c:pt>
                <c:pt idx="3">
                  <c:v>1960.9825</c:v>
                </c:pt>
                <c:pt idx="4">
                  <c:v>8289.24</c:v>
                </c:pt>
              </c:numCache>
            </c:numRef>
          </c:yVal>
          <c:smooth val="1"/>
        </c:ser>
        <c:ser>
          <c:idx val="1"/>
          <c:order val="1"/>
          <c:tx>
            <c:v>Q64</c:v>
          </c:tx>
          <c:spPr>
            <a:ln w="12700">
              <a:noFill/>
            </a:ln>
          </c:spPr>
          <c:marker>
            <c:symbol val="diamond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[20140318.xlsx]Sheet1'!$F$27:$F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2.29499999999996</c:v>
                  </c:pt>
                  <c:pt idx="2">
                    <c:v>14.33750000000001</c:v>
                  </c:pt>
                  <c:pt idx="3">
                    <c:v>198.9475000000001</c:v>
                  </c:pt>
                  <c:pt idx="4">
                    <c:v>941.0699999999994</c:v>
                  </c:pt>
                </c:numCache>
              </c:numRef>
            </c:plus>
            <c:minus>
              <c:numRef>
                <c:f>'[20140318.xlsx]Sheet1'!$F$27:$F$31</c:f>
                <c:numCache>
                  <c:formatCode>General</c:formatCode>
                  <c:ptCount val="5"/>
                  <c:pt idx="0">
                    <c:v>12.84249999999997</c:v>
                  </c:pt>
                  <c:pt idx="1">
                    <c:v>2.29499999999996</c:v>
                  </c:pt>
                  <c:pt idx="2">
                    <c:v>14.33750000000001</c:v>
                  </c:pt>
                  <c:pt idx="3">
                    <c:v>198.9475000000001</c:v>
                  </c:pt>
                  <c:pt idx="4">
                    <c:v>941.0699999999994</c:v>
                  </c:pt>
                </c:numCache>
              </c:numRef>
            </c:minus>
          </c:errBars>
          <c:errBars>
            <c:errDir val="x"/>
            <c:errBarType val="both"/>
            <c:errValType val="cust"/>
            <c:plus>
              <c:numRef>
                <c:f>'[20140318.xlsx]Sheet1'!$Q$25:$Q$29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907399712778613</c:v>
                  </c:pt>
                  <c:pt idx="2">
                    <c:v>2.40903138979708</c:v>
                  </c:pt>
                  <c:pt idx="3">
                    <c:v>1.310858778037772</c:v>
                  </c:pt>
                  <c:pt idx="4">
                    <c:v>0.36973681847477</c:v>
                  </c:pt>
                </c:numCache>
              </c:numRef>
            </c:plus>
            <c:minus>
              <c:numRef>
                <c:f>'[20140318.xlsx]Sheet1'!$Q$25:$Q$29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907399712778613</c:v>
                  </c:pt>
                  <c:pt idx="2">
                    <c:v>2.40903138979708</c:v>
                  </c:pt>
                  <c:pt idx="3">
                    <c:v>1.310858778037772</c:v>
                  </c:pt>
                  <c:pt idx="4">
                    <c:v>0.36973681847477</c:v>
                  </c:pt>
                </c:numCache>
              </c:numRef>
            </c:minus>
          </c:errBars>
          <c:xVal>
            <c:numRef>
              <c:f>'[20140318.xlsx]Sheet1'!$P$25:$P$29</c:f>
              <c:numCache>
                <c:formatCode>General</c:formatCode>
                <c:ptCount val="5"/>
                <c:pt idx="0">
                  <c:v>0.0</c:v>
                </c:pt>
                <c:pt idx="1">
                  <c:v>17.99297128141018</c:v>
                </c:pt>
                <c:pt idx="2">
                  <c:v>28.76268352886158</c:v>
                </c:pt>
                <c:pt idx="3">
                  <c:v>40.71456361957455</c:v>
                </c:pt>
                <c:pt idx="4">
                  <c:v>48.19097548079426</c:v>
                </c:pt>
              </c:numCache>
            </c:numRef>
          </c:xVal>
          <c:yVal>
            <c:numRef>
              <c:f>'[20140318.xlsx]Sheet1'!$E$27:$E$31</c:f>
              <c:numCache>
                <c:formatCode>General</c:formatCode>
                <c:ptCount val="5"/>
                <c:pt idx="0">
                  <c:v>35.8075</c:v>
                </c:pt>
                <c:pt idx="1">
                  <c:v>454.285</c:v>
                </c:pt>
                <c:pt idx="2">
                  <c:v>462.5775000000001</c:v>
                </c:pt>
                <c:pt idx="3">
                  <c:v>1036.3325</c:v>
                </c:pt>
                <c:pt idx="4">
                  <c:v>4205.934999999999</c:v>
                </c:pt>
              </c:numCache>
            </c:numRef>
          </c:yVal>
          <c:smooth val="1"/>
        </c:ser>
        <c:ser>
          <c:idx val="2"/>
          <c:order val="2"/>
          <c:spPr>
            <a:ln w="19050">
              <a:solidFill>
                <a:schemeClr val="tx1"/>
              </a:solidFill>
              <a:prstDash val="sysDot"/>
            </a:ln>
          </c:spPr>
          <c:marker>
            <c:symbol val="none"/>
          </c:marker>
          <c:xVal>
            <c:numRef>
              <c:f>'[20140318.xlsx]Sheet1'!$X$88:$X$103</c:f>
              <c:numCache>
                <c:formatCode>General</c:formatCode>
                <c:ptCount val="1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0</c:v>
                </c:pt>
                <c:pt idx="4">
                  <c:v>8.0</c:v>
                </c:pt>
                <c:pt idx="5">
                  <c:v>10.0</c:v>
                </c:pt>
                <c:pt idx="6">
                  <c:v>12.0</c:v>
                </c:pt>
                <c:pt idx="7">
                  <c:v>14.0</c:v>
                </c:pt>
                <c:pt idx="8">
                  <c:v>16.0</c:v>
                </c:pt>
                <c:pt idx="9">
                  <c:v>18.0</c:v>
                </c:pt>
                <c:pt idx="10">
                  <c:v>20.0</c:v>
                </c:pt>
                <c:pt idx="11">
                  <c:v>22.0</c:v>
                </c:pt>
                <c:pt idx="12">
                  <c:v>24.0</c:v>
                </c:pt>
                <c:pt idx="13">
                  <c:v>26.0</c:v>
                </c:pt>
                <c:pt idx="14">
                  <c:v>28.0</c:v>
                </c:pt>
                <c:pt idx="15">
                  <c:v>30.0</c:v>
                </c:pt>
              </c:numCache>
            </c:numRef>
          </c:xVal>
          <c:yVal>
            <c:numRef>
              <c:f>'[20140318.xlsx]Sheet1'!$Y$88:$Y$103</c:f>
              <c:numCache>
                <c:formatCode>General</c:formatCode>
                <c:ptCount val="16"/>
                <c:pt idx="0">
                  <c:v>10.218348353524</c:v>
                </c:pt>
                <c:pt idx="1">
                  <c:v>29.5298057164679</c:v>
                </c:pt>
                <c:pt idx="2">
                  <c:v>73.3578739209679</c:v>
                </c:pt>
                <c:pt idx="3">
                  <c:v>160.067483555894</c:v>
                </c:pt>
                <c:pt idx="4">
                  <c:v>312.506438020453</c:v>
                </c:pt>
                <c:pt idx="5">
                  <c:v>554.624486151113</c:v>
                </c:pt>
                <c:pt idx="6">
                  <c:v>907.04060091413</c:v>
                </c:pt>
                <c:pt idx="7">
                  <c:v>1382.9419850521</c:v>
                </c:pt>
                <c:pt idx="8">
                  <c:v>1985.50572971507</c:v>
                </c:pt>
                <c:pt idx="9">
                  <c:v>2707.38487632579</c:v>
                </c:pt>
                <c:pt idx="10">
                  <c:v>3532.08992501358</c:v>
                </c:pt>
                <c:pt idx="11">
                  <c:v>4436.62534792491</c:v>
                </c:pt>
                <c:pt idx="12">
                  <c:v>5394.6009376813</c:v>
                </c:pt>
                <c:pt idx="13">
                  <c:v>6379.15747912504</c:v>
                </c:pt>
                <c:pt idx="14">
                  <c:v>7365.2900427724</c:v>
                </c:pt>
                <c:pt idx="15">
                  <c:v>8331.40252267044</c:v>
                </c:pt>
              </c:numCache>
            </c:numRef>
          </c:yVal>
          <c:smooth val="1"/>
        </c:ser>
        <c:ser>
          <c:idx val="3"/>
          <c:order val="3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[20140318.xlsx]Sheet1'!$Y$109:$Y$159</c:f>
              <c:numCache>
                <c:formatCode>General</c:formatCode>
                <c:ptCount val="51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  <c:pt idx="13">
                  <c:v>13.0</c:v>
                </c:pt>
                <c:pt idx="14">
                  <c:v>14.0</c:v>
                </c:pt>
                <c:pt idx="15">
                  <c:v>15.0</c:v>
                </c:pt>
                <c:pt idx="16">
                  <c:v>16.0</c:v>
                </c:pt>
                <c:pt idx="17">
                  <c:v>17.0</c:v>
                </c:pt>
                <c:pt idx="18">
                  <c:v>18.0</c:v>
                </c:pt>
                <c:pt idx="19">
                  <c:v>19.0</c:v>
                </c:pt>
                <c:pt idx="20">
                  <c:v>20.0</c:v>
                </c:pt>
                <c:pt idx="21">
                  <c:v>21.0</c:v>
                </c:pt>
                <c:pt idx="22">
                  <c:v>22.0</c:v>
                </c:pt>
                <c:pt idx="23">
                  <c:v>23.0</c:v>
                </c:pt>
                <c:pt idx="24">
                  <c:v>24.0</c:v>
                </c:pt>
                <c:pt idx="25">
                  <c:v>25.0</c:v>
                </c:pt>
                <c:pt idx="26">
                  <c:v>26.0</c:v>
                </c:pt>
                <c:pt idx="27">
                  <c:v>27.0</c:v>
                </c:pt>
                <c:pt idx="28">
                  <c:v>28.0</c:v>
                </c:pt>
                <c:pt idx="29">
                  <c:v>29.0</c:v>
                </c:pt>
                <c:pt idx="30">
                  <c:v>30.0</c:v>
                </c:pt>
                <c:pt idx="31">
                  <c:v>31.0</c:v>
                </c:pt>
                <c:pt idx="32">
                  <c:v>32.0</c:v>
                </c:pt>
                <c:pt idx="33">
                  <c:v>33.0</c:v>
                </c:pt>
                <c:pt idx="34">
                  <c:v>34.0</c:v>
                </c:pt>
                <c:pt idx="35">
                  <c:v>35.0</c:v>
                </c:pt>
                <c:pt idx="36">
                  <c:v>36.0</c:v>
                </c:pt>
                <c:pt idx="37">
                  <c:v>37.0</c:v>
                </c:pt>
                <c:pt idx="38">
                  <c:v>38.0</c:v>
                </c:pt>
                <c:pt idx="39">
                  <c:v>39.0</c:v>
                </c:pt>
                <c:pt idx="40">
                  <c:v>40.0</c:v>
                </c:pt>
                <c:pt idx="41">
                  <c:v>41.0</c:v>
                </c:pt>
                <c:pt idx="42">
                  <c:v>42.0</c:v>
                </c:pt>
                <c:pt idx="43">
                  <c:v>43.0</c:v>
                </c:pt>
                <c:pt idx="44">
                  <c:v>44.0</c:v>
                </c:pt>
                <c:pt idx="45">
                  <c:v>45.0</c:v>
                </c:pt>
                <c:pt idx="46">
                  <c:v>46.0</c:v>
                </c:pt>
                <c:pt idx="47">
                  <c:v>47.0</c:v>
                </c:pt>
                <c:pt idx="48">
                  <c:v>48.0</c:v>
                </c:pt>
              </c:numCache>
            </c:numRef>
          </c:xVal>
          <c:yVal>
            <c:numRef>
              <c:f>'[20140318.xlsx]Sheet1'!$Z$109:$Z$159</c:f>
              <c:numCache>
                <c:formatCode>General</c:formatCode>
                <c:ptCount val="51"/>
                <c:pt idx="0">
                  <c:v>40.83379726573682</c:v>
                </c:pt>
                <c:pt idx="1">
                  <c:v>84.9731662296954</c:v>
                </c:pt>
                <c:pt idx="2">
                  <c:v>97.92170791230129</c:v>
                </c:pt>
                <c:pt idx="3">
                  <c:v>108.517358076028</c:v>
                </c:pt>
                <c:pt idx="4">
                  <c:v>118.123854502721</c:v>
                </c:pt>
                <c:pt idx="5">
                  <c:v>127.240042988649</c:v>
                </c:pt>
                <c:pt idx="6">
                  <c:v>136.117628101078</c:v>
                </c:pt>
                <c:pt idx="7">
                  <c:v>144.908513329859</c:v>
                </c:pt>
                <c:pt idx="8">
                  <c:v>153.716458058929</c:v>
                </c:pt>
                <c:pt idx="9">
                  <c:v>162.6194657740672</c:v>
                </c:pt>
                <c:pt idx="10">
                  <c:v>171.6809622998503</c:v>
                </c:pt>
                <c:pt idx="11">
                  <c:v>180.956005647832</c:v>
                </c:pt>
                <c:pt idx="12">
                  <c:v>190.495058874797</c:v>
                </c:pt>
                <c:pt idx="13">
                  <c:v>200.346480336365</c:v>
                </c:pt>
                <c:pt idx="14">
                  <c:v>210.558308915066</c:v>
                </c:pt>
                <c:pt idx="15">
                  <c:v>221.1796571961172</c:v>
                </c:pt>
                <c:pt idx="16">
                  <c:v>232.261895643156</c:v>
                </c:pt>
                <c:pt idx="17">
                  <c:v>243.859744043058</c:v>
                </c:pt>
                <c:pt idx="18">
                  <c:v>256.032351595024</c:v>
                </c:pt>
                <c:pt idx="19">
                  <c:v>268.844429508187</c:v>
                </c:pt>
                <c:pt idx="20">
                  <c:v>282.367492851163</c:v>
                </c:pt>
                <c:pt idx="21">
                  <c:v>296.6812683081889</c:v>
                </c:pt>
                <c:pt idx="22">
                  <c:v>311.875330007648</c:v>
                </c:pt>
                <c:pt idx="23">
                  <c:v>328.0510364327722</c:v>
                </c:pt>
                <c:pt idx="24">
                  <c:v>345.323858196281</c:v>
                </c:pt>
                <c:pt idx="25">
                  <c:v>363.8262105722762</c:v>
                </c:pt>
                <c:pt idx="26">
                  <c:v>383.710938500851</c:v>
                </c:pt>
                <c:pt idx="27">
                  <c:v>405.155648976931</c:v>
                </c:pt>
                <c:pt idx="28">
                  <c:v>428.3681518476002</c:v>
                </c:pt>
                <c:pt idx="29">
                  <c:v>453.5933634588692</c:v>
                </c:pt>
                <c:pt idx="30">
                  <c:v>481.122161131966</c:v>
                </c:pt>
                <c:pt idx="31">
                  <c:v>511.302869981234</c:v>
                </c:pt>
                <c:pt idx="32">
                  <c:v>544.556348450085</c:v>
                </c:pt>
                <c:pt idx="33">
                  <c:v>581.396065537526</c:v>
                </c:pt>
                <c:pt idx="34">
                  <c:v>622.4552138401564</c:v>
                </c:pt>
                <c:pt idx="35">
                  <c:v>668.523917648186</c:v>
                </c:pt>
                <c:pt idx="36">
                  <c:v>720.6012153404429</c:v>
                </c:pt>
                <c:pt idx="37">
                  <c:v>779.969149052662</c:v>
                </c:pt>
                <c:pt idx="38">
                  <c:v>848.3007708244884</c:v>
                </c:pt>
                <c:pt idx="39">
                  <c:v>927.8216787159022</c:v>
                </c:pt>
                <c:pt idx="40">
                  <c:v>1021.55882557528</c:v>
                </c:pt>
                <c:pt idx="41">
                  <c:v>1133.73705633807</c:v>
                </c:pt>
                <c:pt idx="42">
                  <c:v>1270.4369477166</c:v>
                </c:pt>
                <c:pt idx="43">
                  <c:v>1440.73962477375</c:v>
                </c:pt>
                <c:pt idx="44">
                  <c:v>1658.83832633523</c:v>
                </c:pt>
                <c:pt idx="45">
                  <c:v>1948.22517159812</c:v>
                </c:pt>
                <c:pt idx="46">
                  <c:v>2350.79858204583</c:v>
                </c:pt>
                <c:pt idx="47">
                  <c:v>2949.28198108323</c:v>
                </c:pt>
                <c:pt idx="48">
                  <c:v>3932.96184478991</c:v>
                </c:pt>
              </c:numCache>
            </c:numRef>
          </c:yVal>
        </c:ser>
        <c:axId val="482519416"/>
        <c:axId val="483072872"/>
      </c:scatterChart>
      <c:valAx>
        <c:axId val="482519416"/>
        <c:scaling>
          <c:orientation val="minMax"/>
          <c:max val="50.0"/>
          <c:min val="0.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R-DNA binding (%)</a:t>
                </a:r>
              </a:p>
            </c:rich>
          </c:tx>
          <c:layout>
            <c:manualLayout>
              <c:xMode val="edge"/>
              <c:yMode val="edge"/>
              <c:x val="0.346469143762325"/>
              <c:y val="0.862043956486158"/>
            </c:manualLayout>
          </c:layout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83072872"/>
        <c:crosses val="autoZero"/>
        <c:crossBetween val="midCat"/>
      </c:valAx>
      <c:valAx>
        <c:axId val="483072872"/>
        <c:scaling>
          <c:orientation val="minMax"/>
          <c:max val="10000.0"/>
        </c:scaling>
        <c:axPos val="l"/>
        <c:majorGridlines>
          <c:spPr>
            <a:ln w="6350">
              <a:prstDash val="sysDash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MTV trx. (A.U.)</a:t>
                </a:r>
              </a:p>
            </c:rich>
          </c:tx>
          <c:layout/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82519416"/>
        <c:crosses val="autoZero"/>
        <c:crossBetween val="midCat"/>
      </c:valAx>
    </c:plotArea>
    <c:legend>
      <c:legendPos val="r"/>
      <c:legendEntry>
        <c:idx val="3"/>
        <c:delete val="1"/>
      </c:legendEntry>
      <c:legendEntry>
        <c:idx val="2"/>
        <c:delete val="1"/>
      </c:legendEntry>
      <c:layout>
        <c:manualLayout>
          <c:xMode val="edge"/>
          <c:yMode val="edge"/>
          <c:x val="0.813603065553476"/>
          <c:y val="0.415656814208694"/>
          <c:w val="0.134823314275147"/>
          <c:h val="0.168686371582612"/>
        </c:manualLayout>
      </c:layout>
      <c:txPr>
        <a:bodyPr/>
        <a:lstStyle/>
        <a:p>
          <a:pPr>
            <a:defRPr sz="1000"/>
          </a:pPr>
          <a:endParaRPr lang="en-US"/>
        </a:p>
      </c:txPr>
    </c:legend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autoTitleDeleted val="1"/>
    <c:plotArea>
      <c:layout>
        <c:manualLayout>
          <c:layoutTarget val="inner"/>
          <c:xMode val="edge"/>
          <c:yMode val="edge"/>
          <c:x val="0.173884140283528"/>
          <c:y val="0.0295121776462683"/>
          <c:w val="0.538140885820511"/>
          <c:h val="0.587208581769453"/>
        </c:manualLayout>
      </c:layout>
      <c:scatterChart>
        <c:scatterStyle val="lineMarker"/>
        <c:ser>
          <c:idx val="0"/>
          <c:order val="0"/>
          <c:tx>
            <c:v>Q25</c:v>
          </c:tx>
          <c:spPr>
            <a:ln>
              <a:noFill/>
            </a:ln>
          </c:spPr>
          <c:marker>
            <c:symbol val="diamond"/>
            <c:size val="4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x"/>
            <c:errBarType val="both"/>
            <c:errValType val="cust"/>
            <c:plus>
              <c:numRef>
                <c:f>'[20140318.xlsx]Sheet4'!$D$44:$D$48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690977787955118</c:v>
                  </c:pt>
                  <c:pt idx="2">
                    <c:v>0.0381984199679414</c:v>
                  </c:pt>
                  <c:pt idx="3">
                    <c:v>0.187829173345546</c:v>
                  </c:pt>
                  <c:pt idx="4">
                    <c:v>0.059852301351042</c:v>
                  </c:pt>
                </c:numCache>
              </c:numRef>
            </c:plus>
            <c:minus>
              <c:numRef>
                <c:f>'[20140318.xlsx]Sheet4'!$D$44:$D$48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690977787955118</c:v>
                  </c:pt>
                  <c:pt idx="2">
                    <c:v>0.0381984199679414</c:v>
                  </c:pt>
                  <c:pt idx="3">
                    <c:v>0.187829173345546</c:v>
                  </c:pt>
                  <c:pt idx="4">
                    <c:v>0.059852301351042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plus>
              <c:numRef>
                <c:f>'[20140318.xlsx]Sheet4'!$E$37:$E$41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003449595468908</c:v>
                  </c:pt>
                  <c:pt idx="2">
                    <c:v>2.730638909289304</c:v>
                  </c:pt>
                  <c:pt idx="3">
                    <c:v>2.871340801230929</c:v>
                  </c:pt>
                  <c:pt idx="4">
                    <c:v>1.547022972313371</c:v>
                  </c:pt>
                </c:numCache>
              </c:numRef>
            </c:plus>
            <c:minus>
              <c:numRef>
                <c:f>'[20140318.xlsx]Sheet4'!$E$37:$E$41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003449595468908</c:v>
                  </c:pt>
                  <c:pt idx="2">
                    <c:v>2.730638909289304</c:v>
                  </c:pt>
                  <c:pt idx="3">
                    <c:v>2.871340801230929</c:v>
                  </c:pt>
                  <c:pt idx="4">
                    <c:v>1.547022972313371</c:v>
                  </c:pt>
                </c:numCache>
              </c:numRef>
            </c:minus>
          </c:errBars>
          <c:xVal>
            <c:numRef>
              <c:f>'[20140318.xlsx]Sheet4'!$C$44:$C$48</c:f>
              <c:numCache>
                <c:formatCode>General</c:formatCode>
                <c:ptCount val="5"/>
                <c:pt idx="0">
                  <c:v>0.0</c:v>
                </c:pt>
                <c:pt idx="1">
                  <c:v>0.487777650561026</c:v>
                </c:pt>
                <c:pt idx="2">
                  <c:v>0.53862777650561</c:v>
                </c:pt>
                <c:pt idx="3">
                  <c:v>1.199192809709182</c:v>
                </c:pt>
                <c:pt idx="4">
                  <c:v>1.406486146095718</c:v>
                </c:pt>
              </c:numCache>
            </c:numRef>
          </c:xVal>
          <c:yVal>
            <c:numRef>
              <c:f>'[20140318.xlsx]Sheet4'!$E$30:$E$34</c:f>
              <c:numCache>
                <c:formatCode>General</c:formatCode>
                <c:ptCount val="5"/>
                <c:pt idx="0">
                  <c:v>0.0</c:v>
                </c:pt>
                <c:pt idx="1">
                  <c:v>6.614543399242649</c:v>
                </c:pt>
                <c:pt idx="2">
                  <c:v>10.27980441847973</c:v>
                </c:pt>
                <c:pt idx="3">
                  <c:v>15.8569383300288</c:v>
                </c:pt>
                <c:pt idx="4">
                  <c:v>29.91375654266962</c:v>
                </c:pt>
              </c:numCache>
            </c:numRef>
          </c:yVal>
        </c:ser>
        <c:ser>
          <c:idx val="1"/>
          <c:order val="1"/>
          <c:tx>
            <c:v>Q64</c:v>
          </c:tx>
          <c:spPr>
            <a:ln>
              <a:noFill/>
            </a:ln>
          </c:spPr>
          <c:marker>
            <c:symbol val="diamond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x"/>
            <c:errBarType val="both"/>
            <c:errValType val="cust"/>
            <c:plus>
              <c:numRef>
                <c:f>'[20140318.xlsx]Sheet4'!$F$44:$F$48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313859629035952</c:v>
                  </c:pt>
                  <c:pt idx="2">
                    <c:v>1.11022302462516E-16</c:v>
                  </c:pt>
                  <c:pt idx="3">
                    <c:v>0.14500801465537</c:v>
                  </c:pt>
                  <c:pt idx="4">
                    <c:v>0.223594572933364</c:v>
                  </c:pt>
                </c:numCache>
              </c:numRef>
            </c:plus>
            <c:minus>
              <c:numRef>
                <c:f>'[20140318.xlsx]Sheet4'!$F$44:$F$48</c:f>
                <c:numCache>
                  <c:formatCode>General</c:formatCode>
                  <c:ptCount val="5"/>
                  <c:pt idx="0">
                    <c:v>0.0</c:v>
                  </c:pt>
                  <c:pt idx="1">
                    <c:v>0.0313859629035952</c:v>
                  </c:pt>
                  <c:pt idx="2">
                    <c:v>1.11022302462516E-16</c:v>
                  </c:pt>
                  <c:pt idx="3">
                    <c:v>0.14500801465537</c:v>
                  </c:pt>
                  <c:pt idx="4">
                    <c:v>0.223594572933364</c:v>
                  </c:pt>
                </c:numCache>
              </c:numRef>
            </c:minus>
          </c:errBars>
          <c:errBars>
            <c:errDir val="y"/>
            <c:errBarType val="both"/>
            <c:errValType val="cust"/>
            <c:plus>
              <c:numRef>
                <c:f>'[20140318.xlsx]Sheet4'!$F$37:$F$41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907399712778613</c:v>
                  </c:pt>
                  <c:pt idx="2">
                    <c:v>2.40903138979708</c:v>
                  </c:pt>
                  <c:pt idx="3">
                    <c:v>1.310858778037772</c:v>
                  </c:pt>
                  <c:pt idx="4">
                    <c:v>0.36973681847477</c:v>
                  </c:pt>
                </c:numCache>
              </c:numRef>
            </c:plus>
            <c:minus>
              <c:numRef>
                <c:f>'[20140318.xlsx]Sheet4'!$F$37:$F$41</c:f>
                <c:numCache>
                  <c:formatCode>General</c:formatCode>
                  <c:ptCount val="5"/>
                  <c:pt idx="0">
                    <c:v>0.310415395028762</c:v>
                  </c:pt>
                  <c:pt idx="1">
                    <c:v>1.907399712778613</c:v>
                  </c:pt>
                  <c:pt idx="2">
                    <c:v>2.40903138979708</c:v>
                  </c:pt>
                  <c:pt idx="3">
                    <c:v>1.310858778037772</c:v>
                  </c:pt>
                  <c:pt idx="4">
                    <c:v>0.36973681847477</c:v>
                  </c:pt>
                </c:numCache>
              </c:numRef>
            </c:minus>
          </c:errBars>
          <c:xVal>
            <c:numRef>
              <c:f>'[20140318.xlsx]Sheet4'!$E$44:$E$48</c:f>
              <c:numCache>
                <c:formatCode>General</c:formatCode>
                <c:ptCount val="5"/>
                <c:pt idx="0">
                  <c:v>0.0</c:v>
                </c:pt>
                <c:pt idx="1">
                  <c:v>0.48510132814289</c:v>
                </c:pt>
                <c:pt idx="2">
                  <c:v>0.586558277994046</c:v>
                </c:pt>
                <c:pt idx="3">
                  <c:v>1.090193496679643</c:v>
                </c:pt>
                <c:pt idx="4">
                  <c:v>1.740053240210671</c:v>
                </c:pt>
              </c:numCache>
            </c:numRef>
          </c:xVal>
          <c:yVal>
            <c:numRef>
              <c:f>'[20140318.xlsx]Sheet4'!$F$30:$F$34</c:f>
              <c:numCache>
                <c:formatCode>General</c:formatCode>
                <c:ptCount val="5"/>
                <c:pt idx="0">
                  <c:v>0.0</c:v>
                </c:pt>
                <c:pt idx="1">
                  <c:v>17.99297128141018</c:v>
                </c:pt>
                <c:pt idx="2">
                  <c:v>28.76268352886158</c:v>
                </c:pt>
                <c:pt idx="3">
                  <c:v>40.71456361957455</c:v>
                </c:pt>
                <c:pt idx="4">
                  <c:v>48.19097548079426</c:v>
                </c:pt>
              </c:numCache>
            </c:numRef>
          </c:yVal>
        </c:ser>
        <c:ser>
          <c:idx val="2"/>
          <c:order val="2"/>
          <c:spPr>
            <a:ln w="1270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[20140318.xlsx]Sheet4'!$D$92:$D$110</c:f>
              <c:numCache>
                <c:formatCode>General</c:formatCode>
                <c:ptCount val="19"/>
                <c:pt idx="0">
                  <c:v>0.0</c:v>
                </c:pt>
                <c:pt idx="1">
                  <c:v>0.1</c:v>
                </c:pt>
                <c:pt idx="2">
                  <c:v>0.2</c:v>
                </c:pt>
                <c:pt idx="3">
                  <c:v>0.3</c:v>
                </c:pt>
                <c:pt idx="4">
                  <c:v>0.4</c:v>
                </c:pt>
                <c:pt idx="5">
                  <c:v>0.5</c:v>
                </c:pt>
                <c:pt idx="6">
                  <c:v>0.6</c:v>
                </c:pt>
                <c:pt idx="7">
                  <c:v>0.7</c:v>
                </c:pt>
                <c:pt idx="8">
                  <c:v>0.8</c:v>
                </c:pt>
                <c:pt idx="9">
                  <c:v>0.9</c:v>
                </c:pt>
                <c:pt idx="10">
                  <c:v>1.0</c:v>
                </c:pt>
                <c:pt idx="11">
                  <c:v>1.1</c:v>
                </c:pt>
                <c:pt idx="12">
                  <c:v>1.2</c:v>
                </c:pt>
                <c:pt idx="13">
                  <c:v>1.3</c:v>
                </c:pt>
                <c:pt idx="14">
                  <c:v>1.4</c:v>
                </c:pt>
                <c:pt idx="15">
                  <c:v>1.5</c:v>
                </c:pt>
                <c:pt idx="16">
                  <c:v>1.6</c:v>
                </c:pt>
                <c:pt idx="17">
                  <c:v>1.7</c:v>
                </c:pt>
                <c:pt idx="18">
                  <c:v>1.8</c:v>
                </c:pt>
              </c:numCache>
            </c:numRef>
          </c:xVal>
          <c:yVal>
            <c:numRef>
              <c:f>'[20140318.xlsx]Sheet4'!$E$92:$E$110</c:f>
              <c:numCache>
                <c:formatCode>General</c:formatCode>
                <c:ptCount val="19"/>
                <c:pt idx="0">
                  <c:v>0.0</c:v>
                </c:pt>
                <c:pt idx="1">
                  <c:v>0.287901204833612</c:v>
                </c:pt>
                <c:pt idx="2">
                  <c:v>2.65398230368178</c:v>
                </c:pt>
                <c:pt idx="3">
                  <c:v>7.48546132644468</c:v>
                </c:pt>
                <c:pt idx="4">
                  <c:v>14.0165597617623</c:v>
                </c:pt>
                <c:pt idx="5">
                  <c:v>20.8761004813434</c:v>
                </c:pt>
                <c:pt idx="6">
                  <c:v>27.0123133880369</c:v>
                </c:pt>
                <c:pt idx="7">
                  <c:v>32.0024882663711</c:v>
                </c:pt>
                <c:pt idx="8">
                  <c:v>35.8605368548178</c:v>
                </c:pt>
                <c:pt idx="9">
                  <c:v>38.7776726029847</c:v>
                </c:pt>
                <c:pt idx="10">
                  <c:v>40.9712137169419</c:v>
                </c:pt>
                <c:pt idx="11">
                  <c:v>42.6269092203261</c:v>
                </c:pt>
                <c:pt idx="12">
                  <c:v>43.88750116508989</c:v>
                </c:pt>
                <c:pt idx="13">
                  <c:v>44.85784207721804</c:v>
                </c:pt>
                <c:pt idx="14">
                  <c:v>45.61362320174749</c:v>
                </c:pt>
                <c:pt idx="15">
                  <c:v>46.2092979303185</c:v>
                </c:pt>
                <c:pt idx="16">
                  <c:v>46.6841953218259</c:v>
                </c:pt>
                <c:pt idx="17">
                  <c:v>47.0669437371808</c:v>
                </c:pt>
                <c:pt idx="18">
                  <c:v>47.378586944678</c:v>
                </c:pt>
              </c:numCache>
            </c:numRef>
          </c:yVal>
          <c:smooth val="1"/>
        </c:ser>
        <c:ser>
          <c:idx val="3"/>
          <c:order val="3"/>
          <c:spPr>
            <a:ln w="19050">
              <a:solidFill>
                <a:schemeClr val="tx1"/>
              </a:solidFill>
              <a:prstDash val="sysDot"/>
            </a:ln>
          </c:spPr>
          <c:marker>
            <c:symbol val="none"/>
          </c:marker>
          <c:xVal>
            <c:numRef>
              <c:f>'[20140318.xlsx]Sheet4'!$D$114:$D$135</c:f>
              <c:numCache>
                <c:formatCode>General</c:formatCode>
                <c:ptCount val="22"/>
                <c:pt idx="0">
                  <c:v>0.0</c:v>
                </c:pt>
                <c:pt idx="1">
                  <c:v>0.0749999999999999</c:v>
                </c:pt>
                <c:pt idx="2">
                  <c:v>0.149999999999999</c:v>
                </c:pt>
                <c:pt idx="3">
                  <c:v>0.224999999999999</c:v>
                </c:pt>
                <c:pt idx="4">
                  <c:v>0.299999999999999</c:v>
                </c:pt>
                <c:pt idx="5">
                  <c:v>0.375</c:v>
                </c:pt>
                <c:pt idx="6">
                  <c:v>0.449999999999999</c:v>
                </c:pt>
                <c:pt idx="7">
                  <c:v>0.525</c:v>
                </c:pt>
                <c:pt idx="8">
                  <c:v>0.599999999999999</c:v>
                </c:pt>
                <c:pt idx="9">
                  <c:v>0.674999999999999</c:v>
                </c:pt>
                <c:pt idx="10">
                  <c:v>0.75</c:v>
                </c:pt>
                <c:pt idx="11">
                  <c:v>0.824999999999999</c:v>
                </c:pt>
                <c:pt idx="12">
                  <c:v>0.899999999999999</c:v>
                </c:pt>
                <c:pt idx="13">
                  <c:v>0.974999999999999</c:v>
                </c:pt>
                <c:pt idx="14">
                  <c:v>1.05</c:v>
                </c:pt>
                <c:pt idx="15">
                  <c:v>1.125</c:v>
                </c:pt>
                <c:pt idx="16">
                  <c:v>1.2</c:v>
                </c:pt>
                <c:pt idx="17">
                  <c:v>1.27499999999999</c:v>
                </c:pt>
                <c:pt idx="18">
                  <c:v>1.34999999999999</c:v>
                </c:pt>
                <c:pt idx="19">
                  <c:v>1.425</c:v>
                </c:pt>
              </c:numCache>
            </c:numRef>
          </c:xVal>
          <c:yVal>
            <c:numRef>
              <c:f>'[20140318.xlsx]Sheet4'!$F$114:$F$133</c:f>
              <c:numCache>
                <c:formatCode>General</c:formatCode>
                <c:ptCount val="20"/>
                <c:pt idx="0">
                  <c:v>0.0321752469696149</c:v>
                </c:pt>
                <c:pt idx="1">
                  <c:v>0.69830020013339</c:v>
                </c:pt>
                <c:pt idx="2">
                  <c:v>1.44330338896868</c:v>
                </c:pt>
                <c:pt idx="3">
                  <c:v>2.26718481347548</c:v>
                </c:pt>
                <c:pt idx="4">
                  <c:v>3.169944473653798</c:v>
                </c:pt>
                <c:pt idx="5">
                  <c:v>4.15158236950363</c:v>
                </c:pt>
                <c:pt idx="6">
                  <c:v>5.21209850102497</c:v>
                </c:pt>
                <c:pt idx="7">
                  <c:v>6.351492868217829</c:v>
                </c:pt>
                <c:pt idx="8">
                  <c:v>7.5697654710822</c:v>
                </c:pt>
                <c:pt idx="9">
                  <c:v>8.86691630961809</c:v>
                </c:pt>
                <c:pt idx="10">
                  <c:v>10.2429453838254</c:v>
                </c:pt>
                <c:pt idx="11">
                  <c:v>11.6978526937044</c:v>
                </c:pt>
                <c:pt idx="12">
                  <c:v>13.2316382392548</c:v>
                </c:pt>
                <c:pt idx="13">
                  <c:v>14.8443020204767</c:v>
                </c:pt>
                <c:pt idx="14">
                  <c:v>16.5358440373702</c:v>
                </c:pt>
                <c:pt idx="15">
                  <c:v>18.3062642899351</c:v>
                </c:pt>
                <c:pt idx="16">
                  <c:v>20.1555627781716</c:v>
                </c:pt>
                <c:pt idx="17">
                  <c:v>22.08373950207952</c:v>
                </c:pt>
                <c:pt idx="18">
                  <c:v>24.0907944616591</c:v>
                </c:pt>
                <c:pt idx="19">
                  <c:v>26.1767276569102</c:v>
                </c:pt>
              </c:numCache>
            </c:numRef>
          </c:yVal>
          <c:smooth val="1"/>
        </c:ser>
        <c:axId val="482472904"/>
        <c:axId val="485122104"/>
      </c:scatterChart>
      <c:valAx>
        <c:axId val="482472904"/>
        <c:scaling>
          <c:orientation val="minMax"/>
          <c:max val="2.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uclear [AR) (</a:t>
                </a:r>
                <a:r>
                  <a:rPr lang="en-US">
                    <a:latin typeface="Symbol" charset="2"/>
                    <a:cs typeface="Symbol" charset="2"/>
                  </a:rPr>
                  <a:t>m</a:t>
                </a:r>
                <a:r>
                  <a:rPr lang="en-US"/>
                  <a:t>M)</a:t>
                </a:r>
              </a:p>
            </c:rich>
          </c:tx>
          <c:layout>
            <c:manualLayout>
              <c:xMode val="edge"/>
              <c:yMode val="edge"/>
              <c:x val="0.297202997953894"/>
              <c:y val="0.740538771526558"/>
            </c:manualLayout>
          </c:layout>
        </c:title>
        <c:numFmt formatCode="General" sourceLinked="1"/>
        <c:tickLblPos val="nextTo"/>
        <c:spPr>
          <a:ln w="3175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85122104"/>
        <c:crosses val="autoZero"/>
        <c:crossBetween val="midCat"/>
      </c:valAx>
      <c:valAx>
        <c:axId val="485122104"/>
        <c:scaling>
          <c:orientation val="minMax"/>
          <c:max val="50.0"/>
          <c:min val="0.0"/>
        </c:scaling>
        <c:axPos val="l"/>
        <c:majorGridlines>
          <c:spPr>
            <a:ln w="6350">
              <a:prstDash val="sysDash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R-DNA binding (%)</a:t>
                </a:r>
              </a:p>
            </c:rich>
          </c:tx>
          <c:layout/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482472904"/>
        <c:crosses val="autoZero"/>
        <c:crossBetween val="midCat"/>
      </c:valAx>
    </c:plotArea>
    <c:legend>
      <c:legendPos val="r"/>
      <c:legendEntry>
        <c:idx val="3"/>
        <c:delete val="1"/>
      </c:legendEntry>
      <c:legendEntry>
        <c:idx val="2"/>
        <c:delete val="1"/>
      </c:legendEntry>
      <c:layout>
        <c:manualLayout>
          <c:xMode val="edge"/>
          <c:yMode val="edge"/>
          <c:x val="0.724830218204436"/>
          <c:y val="0.278148885450535"/>
          <c:w val="0.121472577390384"/>
          <c:h val="0.222360896751918"/>
        </c:manualLayout>
      </c:layout>
      <c:txPr>
        <a:bodyPr/>
        <a:lstStyle/>
        <a:p>
          <a:pPr>
            <a:defRPr sz="1000"/>
          </a:pPr>
          <a:endParaRPr lang="en-US"/>
        </a:p>
      </c:txPr>
    </c:legend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8"/>
  <c:chart>
    <c:autoTitleDeleted val="1"/>
    <c:plotArea>
      <c:layout>
        <c:manualLayout>
          <c:layoutTarget val="inner"/>
          <c:xMode val="edge"/>
          <c:yMode val="edge"/>
          <c:x val="0.127491028019687"/>
          <c:y val="0.0647623066846024"/>
          <c:w val="0.872508971980313"/>
          <c:h val="0.621047310069545"/>
        </c:manualLayout>
      </c:layout>
      <c:barChart>
        <c:barDir val="col"/>
        <c:grouping val="clustered"/>
        <c:ser>
          <c:idx val="0"/>
          <c:order val="0"/>
          <c:tx>
            <c:strRef>
              <c:f>'[20140318.xlsx]Sheet4'!$C$29</c:f>
              <c:strCache>
                <c:ptCount val="1"/>
                <c:pt idx="0">
                  <c:v>ARE, %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635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'[20140318.xlsx]Sheet4'!$D$30:$D$38</c:f>
                <c:numCache>
                  <c:formatCode>General</c:formatCode>
                  <c:ptCount val="9"/>
                  <c:pt idx="0">
                    <c:v>0.310415395028762</c:v>
                  </c:pt>
                  <c:pt idx="1">
                    <c:v>1.003449595468908</c:v>
                  </c:pt>
                  <c:pt idx="2">
                    <c:v>2.730638909289304</c:v>
                  </c:pt>
                  <c:pt idx="3">
                    <c:v>2.871340801230929</c:v>
                  </c:pt>
                  <c:pt idx="4">
                    <c:v>1.547022972313371</c:v>
                  </c:pt>
                  <c:pt idx="5">
                    <c:v>1.907399712778613</c:v>
                  </c:pt>
                  <c:pt idx="6">
                    <c:v>2.40903138979708</c:v>
                  </c:pt>
                  <c:pt idx="7">
                    <c:v>1.310858778037772</c:v>
                  </c:pt>
                  <c:pt idx="8">
                    <c:v>0.36973681847477</c:v>
                  </c:pt>
                </c:numCache>
              </c:numRef>
            </c:plus>
            <c:minus>
              <c:numRef>
                <c:f>'[20140318.xlsx]Sheet4'!$D$30:$D$38</c:f>
                <c:numCache>
                  <c:formatCode>General</c:formatCode>
                  <c:ptCount val="9"/>
                  <c:pt idx="0">
                    <c:v>0.310415395028762</c:v>
                  </c:pt>
                  <c:pt idx="1">
                    <c:v>1.003449595468908</c:v>
                  </c:pt>
                  <c:pt idx="2">
                    <c:v>2.730638909289304</c:v>
                  </c:pt>
                  <c:pt idx="3">
                    <c:v>2.871340801230929</c:v>
                  </c:pt>
                  <c:pt idx="4">
                    <c:v>1.547022972313371</c:v>
                  </c:pt>
                  <c:pt idx="5">
                    <c:v>1.907399712778613</c:v>
                  </c:pt>
                  <c:pt idx="6">
                    <c:v>2.40903138979708</c:v>
                  </c:pt>
                  <c:pt idx="7">
                    <c:v>1.310858778037772</c:v>
                  </c:pt>
                  <c:pt idx="8">
                    <c:v>0.36973681847477</c:v>
                  </c:pt>
                </c:numCache>
              </c:numRef>
            </c:minus>
          </c:errBars>
          <c:val>
            <c:numRef>
              <c:f>'[20140318.xlsx]Sheet4'!$C$30:$C$38</c:f>
              <c:numCache>
                <c:formatCode>General</c:formatCode>
                <c:ptCount val="9"/>
                <c:pt idx="0">
                  <c:v>99.9999999586223</c:v>
                </c:pt>
                <c:pt idx="1">
                  <c:v>93.38545660075735</c:v>
                </c:pt>
                <c:pt idx="2">
                  <c:v>89.72019558152027</c:v>
                </c:pt>
                <c:pt idx="3">
                  <c:v>84.1430616699712</c:v>
                </c:pt>
                <c:pt idx="4">
                  <c:v>70.0862434573304</c:v>
                </c:pt>
                <c:pt idx="5">
                  <c:v>82.00702871858965</c:v>
                </c:pt>
                <c:pt idx="6">
                  <c:v>71.2373164711384</c:v>
                </c:pt>
                <c:pt idx="7">
                  <c:v>59.28543638042545</c:v>
                </c:pt>
                <c:pt idx="8">
                  <c:v>51.80902451920574</c:v>
                </c:pt>
              </c:numCache>
            </c:numRef>
          </c:val>
        </c:ser>
        <c:axId val="73800872"/>
        <c:axId val="525473000"/>
      </c:barChart>
      <c:catAx>
        <c:axId val="73800872"/>
        <c:scaling>
          <c:orientation val="minMax"/>
        </c:scaling>
        <c:axPos val="b"/>
        <c:maj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chemeClr val="bg1"/>
                </a:solidFill>
              </a:defRPr>
            </a:pPr>
            <a:endParaRPr lang="en-US"/>
          </a:p>
        </c:txPr>
        <c:crossAx val="525473000"/>
        <c:crosses val="autoZero"/>
        <c:auto val="1"/>
        <c:lblAlgn val="ctr"/>
        <c:lblOffset val="100"/>
      </c:catAx>
      <c:valAx>
        <c:axId val="525473000"/>
        <c:scaling>
          <c:orientation val="minMax"/>
          <c:max val="100.0"/>
        </c:scaling>
        <c:axPos val="l"/>
        <c:majorGridlines>
          <c:spPr>
            <a:ln w="6350">
              <a:prstDash val="sysDash"/>
            </a:ln>
          </c:spPr>
        </c:majorGridlines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73800872"/>
        <c:crosses val="autoZero"/>
        <c:crossBetween val="between"/>
        <c:majorUnit val="25.0"/>
      </c:valAx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plotArea>
      <c:layout/>
      <c:scatterChart>
        <c:scatterStyle val="lineMarker"/>
        <c:ser>
          <c:idx val="0"/>
          <c:order val="0"/>
          <c:tx>
            <c:v>AR0</c:v>
          </c:tx>
          <c:spPr>
            <a:ln w="28575">
              <a:noFill/>
            </a:ln>
          </c:spPr>
          <c:marker>
            <c:symbol val="diamond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Sheet2!$P$37:$P$52</c:f>
              <c:numCache>
                <c:formatCode>General</c:formatCode>
                <c:ptCount val="1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.05920505383483</c:v>
                </c:pt>
                <c:pt idx="5">
                  <c:v>1.05920505383483</c:v>
                </c:pt>
                <c:pt idx="6">
                  <c:v>1.05920505383483</c:v>
                </c:pt>
                <c:pt idx="7">
                  <c:v>1.05920505383483</c:v>
                </c:pt>
                <c:pt idx="8">
                  <c:v>1.393973956443263</c:v>
                </c:pt>
                <c:pt idx="9">
                  <c:v>1.393973956443263</c:v>
                </c:pt>
                <c:pt idx="10">
                  <c:v>1.393973956443263</c:v>
                </c:pt>
                <c:pt idx="11">
                  <c:v>1.393973956443263</c:v>
                </c:pt>
                <c:pt idx="12">
                  <c:v>1.73393053669371</c:v>
                </c:pt>
                <c:pt idx="13">
                  <c:v>1.73393053669371</c:v>
                </c:pt>
                <c:pt idx="14">
                  <c:v>1.73393053669371</c:v>
                </c:pt>
                <c:pt idx="15">
                  <c:v>1.73393053669371</c:v>
                </c:pt>
              </c:numCache>
            </c:numRef>
          </c:xVal>
          <c:yVal>
            <c:numRef>
              <c:f>Sheet2!$Q$37:$Q$52</c:f>
              <c:numCache>
                <c:formatCode>General</c:formatCode>
                <c:ptCount val="16"/>
                <c:pt idx="0">
                  <c:v>0.00178087336990152</c:v>
                </c:pt>
                <c:pt idx="1">
                  <c:v>0.00167969833265466</c:v>
                </c:pt>
                <c:pt idx="2">
                  <c:v>0.00634282398826747</c:v>
                </c:pt>
                <c:pt idx="3">
                  <c:v>0.00498364741935301</c:v>
                </c:pt>
                <c:pt idx="4">
                  <c:v>0.05296657735641</c:v>
                </c:pt>
                <c:pt idx="5">
                  <c:v>0.0396482808819457</c:v>
                </c:pt>
                <c:pt idx="6">
                  <c:v>0.0448115599397186</c:v>
                </c:pt>
                <c:pt idx="7">
                  <c:v>0.0729395282340432</c:v>
                </c:pt>
                <c:pt idx="8">
                  <c:v>0.170427134027246</c:v>
                </c:pt>
                <c:pt idx="9">
                  <c:v>0.236108233778703</c:v>
                </c:pt>
                <c:pt idx="10">
                  <c:v>0.258572567449565</c:v>
                </c:pt>
                <c:pt idx="11">
                  <c:v>0.229759553770088</c:v>
                </c:pt>
                <c:pt idx="12">
                  <c:v>0.807545422292079</c:v>
                </c:pt>
                <c:pt idx="13">
                  <c:v>1.192454577707921</c:v>
                </c:pt>
                <c:pt idx="14">
                  <c:v>1.138580562699578</c:v>
                </c:pt>
                <c:pt idx="15">
                  <c:v>0.861419437300422</c:v>
                </c:pt>
              </c:numCache>
            </c:numRef>
          </c:yVal>
        </c:ser>
        <c:ser>
          <c:idx val="1"/>
          <c:order val="1"/>
          <c:tx>
            <c:v>AR13</c:v>
          </c:tx>
          <c:spPr>
            <a:ln w="28575">
              <a:noFill/>
            </a:ln>
          </c:spPr>
          <c:marker>
            <c:symbol val="square"/>
            <c:size val="3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Sheet2!$R$37:$R$52</c:f>
              <c:numCache>
                <c:formatCode>General</c:formatCode>
                <c:ptCount val="1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.465858951261506</c:v>
                </c:pt>
                <c:pt idx="5">
                  <c:v>1.465858951261506</c:v>
                </c:pt>
                <c:pt idx="6">
                  <c:v>1.465858951261506</c:v>
                </c:pt>
                <c:pt idx="7">
                  <c:v>1.465858951261506</c:v>
                </c:pt>
                <c:pt idx="8">
                  <c:v>1.662876396046541</c:v>
                </c:pt>
                <c:pt idx="9">
                  <c:v>1.662876396046541</c:v>
                </c:pt>
                <c:pt idx="10">
                  <c:v>1.662876396046541</c:v>
                </c:pt>
                <c:pt idx="11">
                  <c:v>1.662876396046541</c:v>
                </c:pt>
                <c:pt idx="12">
                  <c:v>2.113248254457074</c:v>
                </c:pt>
                <c:pt idx="13">
                  <c:v>2.113248254457074</c:v>
                </c:pt>
                <c:pt idx="14">
                  <c:v>2.113248254457074</c:v>
                </c:pt>
                <c:pt idx="15">
                  <c:v>2.113248254457074</c:v>
                </c:pt>
              </c:numCache>
            </c:numRef>
          </c:xVal>
          <c:yVal>
            <c:numRef>
              <c:f>Sheet2!$S$37:$S$52</c:f>
              <c:numCache>
                <c:formatCode>General</c:formatCode>
                <c:ptCount val="16"/>
                <c:pt idx="0">
                  <c:v>0.00178087336990152</c:v>
                </c:pt>
                <c:pt idx="1">
                  <c:v>0.00167969833265466</c:v>
                </c:pt>
                <c:pt idx="2">
                  <c:v>0.00634282398826747</c:v>
                </c:pt>
                <c:pt idx="3">
                  <c:v>0.00498364741935301</c:v>
                </c:pt>
                <c:pt idx="4">
                  <c:v>0.232415055847657</c:v>
                </c:pt>
                <c:pt idx="5">
                  <c:v>0.222262670824415</c:v>
                </c:pt>
                <c:pt idx="6">
                  <c:v>0.296881175336805</c:v>
                </c:pt>
                <c:pt idx="7">
                  <c:v>0.306499454728092</c:v>
                </c:pt>
                <c:pt idx="8">
                  <c:v>0.633728250016814</c:v>
                </c:pt>
                <c:pt idx="9">
                  <c:v>0.708117918831411</c:v>
                </c:pt>
                <c:pt idx="10">
                  <c:v>0.514669124831617</c:v>
                </c:pt>
                <c:pt idx="11">
                  <c:v>0.644174011247044</c:v>
                </c:pt>
                <c:pt idx="12">
                  <c:v>1.569465527930381</c:v>
                </c:pt>
                <c:pt idx="13">
                  <c:v>1.478140506881155</c:v>
                </c:pt>
                <c:pt idx="14">
                  <c:v>1.784719130197102</c:v>
                </c:pt>
                <c:pt idx="15">
                  <c:v>1.401772386640285</c:v>
                </c:pt>
              </c:numCache>
            </c:numRef>
          </c:yVal>
        </c:ser>
        <c:ser>
          <c:idx val="2"/>
          <c:order val="2"/>
          <c:tx>
            <c:v>AR25</c:v>
          </c:tx>
          <c:spPr>
            <a:ln w="28575">
              <a:noFill/>
            </a:ln>
          </c:spPr>
          <c:marker>
            <c:symbol val="triang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Sheet2!$T$37:$T$52</c:f>
              <c:numCache>
                <c:formatCode>General</c:formatCode>
                <c:ptCount val="1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970405175758865</c:v>
                </c:pt>
                <c:pt idx="5">
                  <c:v>0.970405175758865</c:v>
                </c:pt>
                <c:pt idx="6">
                  <c:v>0.970405175758865</c:v>
                </c:pt>
                <c:pt idx="7">
                  <c:v>0.970405175758865</c:v>
                </c:pt>
                <c:pt idx="8">
                  <c:v>1.073151785351926</c:v>
                </c:pt>
                <c:pt idx="9">
                  <c:v>1.073151785351926</c:v>
                </c:pt>
                <c:pt idx="10">
                  <c:v>1.073151785351926</c:v>
                </c:pt>
                <c:pt idx="11">
                  <c:v>1.073151785351926</c:v>
                </c:pt>
                <c:pt idx="12">
                  <c:v>1.664854244961271</c:v>
                </c:pt>
                <c:pt idx="13">
                  <c:v>1.664854244961271</c:v>
                </c:pt>
                <c:pt idx="14">
                  <c:v>1.664854244961271</c:v>
                </c:pt>
                <c:pt idx="15">
                  <c:v>1.664854244961271</c:v>
                </c:pt>
              </c:numCache>
            </c:numRef>
          </c:xVal>
          <c:yVal>
            <c:numRef>
              <c:f>Sheet2!$U$37:$U$52</c:f>
              <c:numCache>
                <c:formatCode>General</c:formatCode>
                <c:ptCount val="16"/>
                <c:pt idx="0">
                  <c:v>0.00178087336990152</c:v>
                </c:pt>
                <c:pt idx="1">
                  <c:v>0.00167969833265466</c:v>
                </c:pt>
                <c:pt idx="2">
                  <c:v>0.00634282398826747</c:v>
                </c:pt>
                <c:pt idx="3">
                  <c:v>0.00498364741935301</c:v>
                </c:pt>
                <c:pt idx="4">
                  <c:v>0.0123287082530116</c:v>
                </c:pt>
                <c:pt idx="5">
                  <c:v>0.00716801049599472</c:v>
                </c:pt>
                <c:pt idx="6">
                  <c:v>0.0110630965915586</c:v>
                </c:pt>
                <c:pt idx="7">
                  <c:v>0.00761643959152844</c:v>
                </c:pt>
                <c:pt idx="8">
                  <c:v>0.10313590582589</c:v>
                </c:pt>
                <c:pt idx="9">
                  <c:v>0.108392382618167</c:v>
                </c:pt>
                <c:pt idx="10">
                  <c:v>0.0579912946099061</c:v>
                </c:pt>
                <c:pt idx="11">
                  <c:v>0.0326184850084681</c:v>
                </c:pt>
                <c:pt idx="12">
                  <c:v>0.985223241274328</c:v>
                </c:pt>
                <c:pt idx="13">
                  <c:v>0.687408641350295</c:v>
                </c:pt>
                <c:pt idx="14">
                  <c:v>0.415814104223294</c:v>
                </c:pt>
                <c:pt idx="15">
                  <c:v>0.377862956348054</c:v>
                </c:pt>
              </c:numCache>
            </c:numRef>
          </c:yVal>
        </c:ser>
        <c:ser>
          <c:idx val="3"/>
          <c:order val="3"/>
          <c:spPr>
            <a:ln w="133350" cap="flat">
              <a:solidFill>
                <a:prstClr val="black">
                  <a:alpha val="14000"/>
                </a:prstClr>
              </a:solidFill>
              <a:prstDash val="solid"/>
            </a:ln>
          </c:spPr>
          <c:marker>
            <c:symbol val="none"/>
          </c:marker>
          <c:xVal>
            <c:numRef>
              <c:f>Sheet2!$Z$87:$Z$108</c:f>
              <c:numCache>
                <c:formatCode>General</c:formatCode>
                <c:ptCount val="22"/>
                <c:pt idx="0">
                  <c:v>0.0</c:v>
                </c:pt>
                <c:pt idx="1">
                  <c:v>0.1</c:v>
                </c:pt>
                <c:pt idx="2">
                  <c:v>0.2</c:v>
                </c:pt>
                <c:pt idx="3">
                  <c:v>0.3</c:v>
                </c:pt>
                <c:pt idx="4">
                  <c:v>0.4</c:v>
                </c:pt>
                <c:pt idx="5">
                  <c:v>0.5</c:v>
                </c:pt>
                <c:pt idx="6">
                  <c:v>0.6</c:v>
                </c:pt>
                <c:pt idx="7">
                  <c:v>0.7</c:v>
                </c:pt>
                <c:pt idx="8">
                  <c:v>0.8</c:v>
                </c:pt>
                <c:pt idx="9">
                  <c:v>0.9</c:v>
                </c:pt>
                <c:pt idx="10">
                  <c:v>1.0</c:v>
                </c:pt>
                <c:pt idx="11">
                  <c:v>1.1</c:v>
                </c:pt>
                <c:pt idx="12">
                  <c:v>1.2</c:v>
                </c:pt>
                <c:pt idx="13">
                  <c:v>1.3</c:v>
                </c:pt>
                <c:pt idx="14">
                  <c:v>1.4</c:v>
                </c:pt>
                <c:pt idx="15">
                  <c:v>1.5</c:v>
                </c:pt>
                <c:pt idx="16">
                  <c:v>1.6</c:v>
                </c:pt>
                <c:pt idx="17">
                  <c:v>1.7</c:v>
                </c:pt>
                <c:pt idx="18">
                  <c:v>1.8</c:v>
                </c:pt>
                <c:pt idx="19">
                  <c:v>1.9</c:v>
                </c:pt>
                <c:pt idx="20">
                  <c:v>2.0</c:v>
                </c:pt>
                <c:pt idx="21">
                  <c:v>2.1</c:v>
                </c:pt>
              </c:numCache>
            </c:numRef>
          </c:xVal>
          <c:yVal>
            <c:numRef>
              <c:f>Sheet2!$AA$87:$AA$108</c:f>
              <c:numCache>
                <c:formatCode>General</c:formatCode>
                <c:ptCount val="22"/>
                <c:pt idx="0">
                  <c:v>2.10660951722893E-5</c:v>
                </c:pt>
                <c:pt idx="1">
                  <c:v>4.06151009939783E-5</c:v>
                </c:pt>
                <c:pt idx="2">
                  <c:v>7.83044359460951E-5</c:v>
                </c:pt>
                <c:pt idx="3">
                  <c:v>0.000150964973452623</c:v>
                </c:pt>
                <c:pt idx="4">
                  <c:v>0.000291037316061905</c:v>
                </c:pt>
                <c:pt idx="5">
                  <c:v>0.000561032109699511</c:v>
                </c:pt>
                <c:pt idx="6">
                  <c:v>0.00108134010163465</c:v>
                </c:pt>
                <c:pt idx="7">
                  <c:v>0.00208359220902455</c:v>
                </c:pt>
                <c:pt idx="8">
                  <c:v>0.00401258315453259</c:v>
                </c:pt>
                <c:pt idx="9">
                  <c:v>0.00771925807568941</c:v>
                </c:pt>
                <c:pt idx="10">
                  <c:v>0.0148198871155016</c:v>
                </c:pt>
                <c:pt idx="11">
                  <c:v>0.0283419210782496</c:v>
                </c:pt>
                <c:pt idx="12">
                  <c:v>0.0538050357301868</c:v>
                </c:pt>
                <c:pt idx="13">
                  <c:v>0.100756023758121</c:v>
                </c:pt>
                <c:pt idx="14">
                  <c:v>0.184062443261228</c:v>
                </c:pt>
                <c:pt idx="15">
                  <c:v>0.322262764059381</c:v>
                </c:pt>
                <c:pt idx="16">
                  <c:v>0.52781102034275</c:v>
                </c:pt>
                <c:pt idx="17">
                  <c:v>0.788746010040679</c:v>
                </c:pt>
                <c:pt idx="18">
                  <c:v>1.06073577041809</c:v>
                </c:pt>
                <c:pt idx="19">
                  <c:v>1.29178018376999</c:v>
                </c:pt>
                <c:pt idx="20">
                  <c:v>1.45630528105022</c:v>
                </c:pt>
                <c:pt idx="21">
                  <c:v>1.55931262981224</c:v>
                </c:pt>
              </c:numCache>
            </c:numRef>
          </c:yVal>
          <c:smooth val="1"/>
        </c:ser>
        <c:axId val="73833720"/>
        <c:axId val="476447800"/>
      </c:scatterChart>
      <c:valAx>
        <c:axId val="7383372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[AR] total (A.U.)</a:t>
                </a:r>
              </a:p>
            </c:rich>
          </c:tx>
          <c:layout>
            <c:manualLayout>
              <c:xMode val="edge"/>
              <c:yMode val="edge"/>
              <c:x val="0.364817006744019"/>
              <c:y val="0.796901470645891"/>
            </c:manualLayout>
          </c:layout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chemeClr val="tx1"/>
                </a:solidFill>
              </a:defRPr>
            </a:pPr>
            <a:endParaRPr lang="en-US"/>
          </a:p>
        </c:txPr>
        <c:crossAx val="476447800"/>
        <c:crosses val="autoZero"/>
        <c:crossBetween val="midCat"/>
      </c:valAx>
      <c:valAx>
        <c:axId val="476447800"/>
        <c:scaling>
          <c:orientation val="minMax"/>
          <c:max val="1.8"/>
        </c:scaling>
        <c:axPos val="l"/>
        <c:majorGridlines>
          <c:spPr>
            <a:ln w="6350">
              <a:prstDash val="sysDash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MMTV</a:t>
                </a:r>
                <a:r>
                  <a:rPr lang="en-US" baseline="0" dirty="0" smtClean="0"/>
                  <a:t> trx. </a:t>
                </a:r>
                <a:r>
                  <a:rPr lang="en-US" dirty="0" smtClean="0"/>
                  <a:t> </a:t>
                </a:r>
                <a:r>
                  <a:rPr lang="en-US" dirty="0"/>
                  <a:t>(A.U.)</a:t>
                </a:r>
              </a:p>
            </c:rich>
          </c:tx>
          <c:layout>
            <c:manualLayout>
              <c:xMode val="edge"/>
              <c:yMode val="edge"/>
              <c:x val="0.0561044432068416"/>
              <c:y val="0.118090677792979"/>
            </c:manualLayout>
          </c:layout>
        </c:title>
        <c:numFmt formatCode="General" sourceLinked="1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73833720"/>
        <c:crosses val="autoZero"/>
        <c:crossBetween val="midCat"/>
      </c:valAx>
    </c:plotArea>
    <c:legend>
      <c:legendPos val="r"/>
      <c:legendEntry>
        <c:idx val="3"/>
        <c:delete val="1"/>
      </c:legendEntry>
      <c:layout>
        <c:manualLayout>
          <c:xMode val="edge"/>
          <c:yMode val="edge"/>
          <c:x val="0.785283436407454"/>
          <c:y val="0.231126332753494"/>
          <c:w val="0.14084925820168"/>
          <c:h val="0.364770144459546"/>
        </c:manualLayout>
      </c:layout>
      <c:txPr>
        <a:bodyPr/>
        <a:lstStyle/>
        <a:p>
          <a:pPr>
            <a:defRPr sz="900"/>
          </a:pPr>
          <a:endParaRPr lang="en-US"/>
        </a:p>
      </c:txPr>
    </c:legend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8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1!$E$1</c:f>
              <c:strCache>
                <c:ptCount val="1"/>
                <c:pt idx="0">
                  <c:v>MMTV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effectLst/>
          </c:spPr>
          <c:errBars>
            <c:errBarType val="both"/>
            <c:errValType val="cust"/>
            <c:plus>
              <c:numRef>
                <c:f>Sheet1!$F$2:$F$11</c:f>
                <c:numCache>
                  <c:formatCode>General</c:formatCode>
                  <c:ptCount val="10"/>
                  <c:pt idx="0">
                    <c:v>42.65250000000003</c:v>
                  </c:pt>
                  <c:pt idx="1">
                    <c:v>882.6874999999994</c:v>
                  </c:pt>
                  <c:pt idx="2">
                    <c:v>904.1850000000015</c:v>
                  </c:pt>
                  <c:pt idx="3">
                    <c:v>8697.630000000004</c:v>
                  </c:pt>
                  <c:pt idx="4">
                    <c:v>301.8325000000023</c:v>
                  </c:pt>
                  <c:pt idx="5">
                    <c:v>4064.009999999997</c:v>
                  </c:pt>
                  <c:pt idx="6">
                    <c:v>12017.3025</c:v>
                  </c:pt>
                  <c:pt idx="7">
                    <c:v>108.16</c:v>
                  </c:pt>
                  <c:pt idx="8">
                    <c:v>796.2275</c:v>
                  </c:pt>
                  <c:pt idx="9">
                    <c:v>1190.95</c:v>
                  </c:pt>
                </c:numCache>
              </c:numRef>
            </c:plus>
            <c:minus>
              <c:numRef>
                <c:f>Sheet1!$F$2:$F$11</c:f>
                <c:numCache>
                  <c:formatCode>General</c:formatCode>
                  <c:ptCount val="10"/>
                  <c:pt idx="0">
                    <c:v>42.65250000000003</c:v>
                  </c:pt>
                  <c:pt idx="1">
                    <c:v>882.6874999999994</c:v>
                  </c:pt>
                  <c:pt idx="2">
                    <c:v>904.1850000000015</c:v>
                  </c:pt>
                  <c:pt idx="3">
                    <c:v>8697.630000000004</c:v>
                  </c:pt>
                  <c:pt idx="4">
                    <c:v>301.8325000000023</c:v>
                  </c:pt>
                  <c:pt idx="5">
                    <c:v>4064.009999999997</c:v>
                  </c:pt>
                  <c:pt idx="6">
                    <c:v>12017.3025</c:v>
                  </c:pt>
                  <c:pt idx="7">
                    <c:v>108.16</c:v>
                  </c:pt>
                  <c:pt idx="8">
                    <c:v>796.2275</c:v>
                  </c:pt>
                  <c:pt idx="9">
                    <c:v>1190.95</c:v>
                  </c:pt>
                </c:numCache>
              </c:numRef>
            </c:minus>
          </c:errBars>
          <c:val>
            <c:numRef>
              <c:f>Sheet1!$E$2:$E$11</c:f>
              <c:numCache>
                <c:formatCode>General</c:formatCode>
                <c:ptCount val="10"/>
                <c:pt idx="0">
                  <c:v>355.4374999999989</c:v>
                </c:pt>
                <c:pt idx="1">
                  <c:v>3695.1625</c:v>
                </c:pt>
                <c:pt idx="2">
                  <c:v>15324.415</c:v>
                </c:pt>
                <c:pt idx="3">
                  <c:v>62762.265</c:v>
                </c:pt>
                <c:pt idx="4">
                  <c:v>18934.7675</c:v>
                </c:pt>
                <c:pt idx="5">
                  <c:v>36365.81</c:v>
                </c:pt>
                <c:pt idx="6">
                  <c:v>99995.71249999997</c:v>
                </c:pt>
                <c:pt idx="7">
                  <c:v>586.185</c:v>
                </c:pt>
                <c:pt idx="8">
                  <c:v>2843.4375</c:v>
                </c:pt>
                <c:pt idx="9">
                  <c:v>24906.485</c:v>
                </c:pt>
              </c:numCache>
            </c:numRef>
          </c:val>
        </c:ser>
        <c:axId val="485012280"/>
        <c:axId val="477039560"/>
      </c:barChart>
      <c:catAx>
        <c:axId val="485012280"/>
        <c:scaling>
          <c:orientation val="minMax"/>
        </c:scaling>
        <c:axPos val="b"/>
        <c:tickLblPos val="nextTo"/>
        <c:txPr>
          <a:bodyPr/>
          <a:lstStyle/>
          <a:p>
            <a:pPr>
              <a:defRPr sz="100">
                <a:solidFill>
                  <a:schemeClr val="bg1"/>
                </a:solidFill>
              </a:defRPr>
            </a:pPr>
            <a:endParaRPr lang="en-US"/>
          </a:p>
        </c:txPr>
        <c:crossAx val="477039560"/>
        <c:crosses val="autoZero"/>
        <c:auto val="1"/>
        <c:lblAlgn val="ctr"/>
        <c:lblOffset val="100"/>
      </c:catAx>
      <c:valAx>
        <c:axId val="477039560"/>
        <c:scaling>
          <c:orientation val="minMax"/>
        </c:scaling>
        <c:axPos val="l"/>
        <c:majorGridlines>
          <c:spPr>
            <a:ln w="6350">
              <a:prstDash val="sysDash"/>
            </a:ln>
          </c:spPr>
        </c:majorGridlines>
        <c:numFmt formatCode="General" sourceLinked="1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">
                <a:solidFill>
                  <a:schemeClr val="bg1"/>
                </a:solidFill>
              </a:defRPr>
            </a:pPr>
            <a:endParaRPr lang="en-US"/>
          </a:p>
        </c:txPr>
        <c:crossAx val="485012280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639</cdr:x>
      <cdr:y>0</cdr:y>
    </cdr:from>
    <cdr:to>
      <cdr:x>0.43043</cdr:x>
      <cdr:y>0.14817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010148" y="0"/>
          <a:ext cx="18466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endParaRPr lang="en-US" sz="1200" b="1" dirty="0"/>
        </a:p>
      </cdr:txBody>
    </cdr:sp>
  </cdr:relSizeAnchor>
  <cdr:relSizeAnchor xmlns:cdr="http://schemas.openxmlformats.org/drawingml/2006/chartDrawing">
    <cdr:from>
      <cdr:x>0.3639</cdr:x>
      <cdr:y>0.04076</cdr:y>
    </cdr:from>
    <cdr:to>
      <cdr:x>0.73103</cdr:x>
      <cdr:y>0.18894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1010148" y="76203"/>
          <a:ext cx="1019104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4572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sz="1200" b="1" dirty="0" smtClean="0"/>
            <a:t>Transcription</a:t>
          </a:r>
          <a:endParaRPr lang="en-US" sz="12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6392</cdr:x>
      <cdr:y>0.60319</cdr:y>
    </cdr:from>
    <cdr:to>
      <cdr:x>0.45425</cdr:x>
      <cdr:y>0.86427</cdr:y>
    </cdr:to>
    <cdr:sp macro="" textlink="">
      <cdr:nvSpPr>
        <cdr:cNvPr id="5" name="Freeform 4"/>
        <cdr:cNvSpPr/>
      </cdr:nvSpPr>
      <cdr:spPr>
        <a:xfrm xmlns:a="http://schemas.openxmlformats.org/drawingml/2006/main">
          <a:off x="521645" y="2213904"/>
          <a:ext cx="923925" cy="958219"/>
        </a:xfrm>
        <a:custGeom xmlns:a="http://schemas.openxmlformats.org/drawingml/2006/main">
          <a:avLst/>
          <a:gdLst>
            <a:gd name="connsiteX0" fmla="*/ 0 w 1063625"/>
            <a:gd name="connsiteY0" fmla="*/ 936625 h 936625"/>
            <a:gd name="connsiteX1" fmla="*/ 603250 w 1063625"/>
            <a:gd name="connsiteY1" fmla="*/ 704850 h 936625"/>
            <a:gd name="connsiteX2" fmla="*/ 1063625 w 1063625"/>
            <a:gd name="connsiteY2" fmla="*/ 0 h 936625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</a:cxnLst>
          <a:rect l="l" t="t" r="r" b="b"/>
          <a:pathLst>
            <a:path w="1063625" h="936625">
              <a:moveTo>
                <a:pt x="0" y="936625"/>
              </a:moveTo>
              <a:cubicBezTo>
                <a:pt x="212989" y="898789"/>
                <a:pt x="425979" y="860954"/>
                <a:pt x="603250" y="704850"/>
              </a:cubicBezTo>
              <a:cubicBezTo>
                <a:pt x="780521" y="548746"/>
                <a:pt x="1063625" y="0"/>
                <a:pt x="1063625" y="0"/>
              </a:cubicBezTo>
            </a:path>
          </a:pathLst>
        </a:custGeom>
        <a:ln xmlns:a="http://schemas.openxmlformats.org/drawingml/2006/main" w="19050" cap="rnd">
          <a:solidFill>
            <a:schemeClr val="tx1"/>
          </a:solidFill>
          <a:prstDash val="sysDot"/>
        </a:ln>
        <a:effectLst xmlns:a="http://schemas.openxmlformats.org/drawingml/2006/main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7719B-16E5-824B-978E-1C52B16B9F4F}" type="datetimeFigureOut">
              <a:rPr lang="en-US" smtClean="0"/>
              <a:pPr/>
              <a:t>7/1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AD555-F942-F64A-B1AE-057D24B0C3A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chart" Target="../charts/chart1.xml"/><Relationship Id="rId5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4" Type="http://schemas.openxmlformats.org/officeDocument/2006/relationships/image" Target="../media/image4.tiff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68421" y="561474"/>
            <a:ext cx="5654842" cy="86741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baseline="0" dirty="0" smtClean="0">
                <a:latin typeface="Times New Roman"/>
                <a:cs typeface="Times New Roman"/>
              </a:rPr>
              <a:t>Supplementary information.</a:t>
            </a:r>
          </a:p>
          <a:p>
            <a:pPr algn="ctr">
              <a:lnSpc>
                <a:spcPct val="150000"/>
              </a:lnSpc>
            </a:pPr>
            <a:r>
              <a:rPr lang="en-US" sz="1200" b="1" baseline="0" dirty="0" smtClean="0">
                <a:latin typeface="Times New Roman"/>
                <a:cs typeface="Times New Roman"/>
              </a:rPr>
              <a:t>Belikov S,  </a:t>
            </a:r>
            <a:r>
              <a:rPr lang="en-US" sz="1200" b="1" baseline="0" dirty="0" err="1" smtClean="0">
                <a:latin typeface="Times New Roman"/>
                <a:cs typeface="Times New Roman"/>
              </a:rPr>
              <a:t>Bott</a:t>
            </a:r>
            <a:r>
              <a:rPr lang="en-US" sz="1200" b="1" dirty="0" smtClean="0">
                <a:latin typeface="Times New Roman"/>
                <a:cs typeface="Times New Roman"/>
              </a:rPr>
              <a:t> LC</a:t>
            </a:r>
            <a:r>
              <a:rPr lang="en-US" sz="1200" b="1" baseline="0" dirty="0" smtClean="0">
                <a:latin typeface="Times New Roman"/>
                <a:cs typeface="Times New Roman"/>
              </a:rPr>
              <a:t>,  </a:t>
            </a:r>
            <a:r>
              <a:rPr lang="en-US" sz="1200" b="1" baseline="0" dirty="0" err="1" smtClean="0">
                <a:latin typeface="Times New Roman"/>
                <a:cs typeface="Times New Roman"/>
              </a:rPr>
              <a:t>Fischbeck</a:t>
            </a:r>
            <a:r>
              <a:rPr lang="en-US" sz="1200" b="1" baseline="0" dirty="0" smtClean="0">
                <a:latin typeface="Times New Roman"/>
                <a:cs typeface="Times New Roman"/>
              </a:rPr>
              <a:t> KH</a:t>
            </a:r>
            <a:r>
              <a:rPr lang="en-US" sz="1200" b="1" dirty="0" smtClean="0">
                <a:latin typeface="Times New Roman"/>
                <a:cs typeface="Times New Roman"/>
              </a:rPr>
              <a:t> </a:t>
            </a:r>
            <a:r>
              <a:rPr lang="en-US" sz="1200" b="1" baseline="0" dirty="0" smtClean="0">
                <a:latin typeface="Times New Roman"/>
                <a:cs typeface="Times New Roman"/>
              </a:rPr>
              <a:t>and Wrange Ö</a:t>
            </a:r>
          </a:p>
          <a:p>
            <a:pPr algn="ctr">
              <a:lnSpc>
                <a:spcPct val="150000"/>
              </a:lnSpc>
            </a:pPr>
            <a:r>
              <a:rPr lang="en-US" sz="1400" b="1" dirty="0" smtClean="0"/>
              <a:t>The </a:t>
            </a:r>
            <a:r>
              <a:rPr lang="en-US" sz="1400" b="1" dirty="0" err="1" smtClean="0"/>
              <a:t>polyglutamine</a:t>
            </a:r>
            <a:r>
              <a:rPr lang="en-US" sz="1400" b="1" dirty="0" smtClean="0"/>
              <a:t>-expanded androgen receptor has increased DNA binding and reduced transcriptional activity </a:t>
            </a:r>
            <a:endParaRPr lang="en-US" sz="1200" b="1" baseline="0" dirty="0" smtClean="0">
              <a:latin typeface="Times New Roman"/>
              <a:cs typeface="Times New Roman"/>
            </a:endParaRPr>
          </a:p>
          <a:p>
            <a:pPr marR="490">
              <a:lnSpc>
                <a:spcPct val="150000"/>
              </a:lnSpc>
            </a:pPr>
            <a:endParaRPr lang="en-US" sz="1200" b="1" baseline="0" smtClean="0">
              <a:latin typeface="Times New Roman"/>
              <a:cs typeface="Times New Roman"/>
            </a:endParaRPr>
          </a:p>
          <a:p>
            <a:pPr marR="490">
              <a:lnSpc>
                <a:spcPct val="150000"/>
              </a:lnSpc>
            </a:pPr>
            <a:r>
              <a:rPr lang="en-US" sz="1200" b="1" baseline="0" smtClean="0">
                <a:latin typeface="Times New Roman"/>
                <a:cs typeface="Times New Roman"/>
              </a:rPr>
              <a:t>Materials </a:t>
            </a:r>
            <a:r>
              <a:rPr lang="en-US" sz="1200" b="1" baseline="0" dirty="0" smtClean="0">
                <a:latin typeface="Times New Roman"/>
                <a:cs typeface="Times New Roman"/>
              </a:rPr>
              <a:t>and methods</a:t>
            </a:r>
          </a:p>
          <a:p>
            <a:pPr marR="490">
              <a:lnSpc>
                <a:spcPct val="150000"/>
              </a:lnSpc>
            </a:pPr>
            <a:r>
              <a:rPr lang="en-US" sz="1200" i="1" baseline="0" dirty="0" smtClean="0">
                <a:latin typeface="Times New Roman"/>
                <a:cs typeface="Times New Roman"/>
              </a:rPr>
              <a:t> Analysis of intracellular amounts of expressed AR by Western blot (WB) </a:t>
            </a:r>
          </a:p>
          <a:p>
            <a:pPr marR="490">
              <a:lnSpc>
                <a:spcPct val="150000"/>
              </a:lnSpc>
            </a:pPr>
            <a:r>
              <a:rPr lang="en-US" sz="1200" baseline="0" dirty="0" smtClean="0">
                <a:latin typeface="Times New Roman"/>
                <a:cs typeface="Times New Roman"/>
              </a:rPr>
              <a:t>	Whole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oocytes</a:t>
            </a:r>
            <a:r>
              <a:rPr lang="en-US" sz="1200" baseline="0" dirty="0" smtClean="0">
                <a:latin typeface="Times New Roman"/>
                <a:cs typeface="Times New Roman"/>
              </a:rPr>
              <a:t> or nuclei, isolated by manual dissection under the microscope, were extracted, the former in buffer (10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mM</a:t>
            </a:r>
            <a:r>
              <a:rPr lang="en-US" sz="1200" baseline="0" dirty="0" smtClean="0">
                <a:latin typeface="Times New Roman"/>
                <a:cs typeface="Times New Roman"/>
              </a:rPr>
              <a:t>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Hepes</a:t>
            </a:r>
            <a:r>
              <a:rPr lang="en-US" sz="1200" baseline="0" dirty="0" smtClean="0">
                <a:latin typeface="Times New Roman"/>
                <a:cs typeface="Times New Roman"/>
              </a:rPr>
              <a:t> pH 7.8; 10% glycerol (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v/v</a:t>
            </a:r>
            <a:r>
              <a:rPr lang="en-US" sz="1200" baseline="0" dirty="0" smtClean="0">
                <a:latin typeface="Times New Roman"/>
                <a:cs typeface="Times New Roman"/>
              </a:rPr>
              <a:t>); 5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mM</a:t>
            </a:r>
            <a:r>
              <a:rPr lang="en-US" sz="1200" baseline="0" dirty="0" smtClean="0">
                <a:latin typeface="Times New Roman"/>
                <a:cs typeface="Times New Roman"/>
              </a:rPr>
              <a:t> DTT; and protease inhibitor, complete mini, EDTA-free, (Roche) one tablet /10 ml), the latter in 1x SDS sample buffer, 30 µ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l</a:t>
            </a:r>
            <a:r>
              <a:rPr lang="en-US" sz="1200" baseline="0" dirty="0" smtClean="0">
                <a:latin typeface="Times New Roman"/>
                <a:cs typeface="Times New Roman"/>
              </a:rPr>
              <a:t>/five nuclei, each nucleus was transferred in a pipette tip with 1µl buffer. Extracts were separated on a 7% SDSPAGE, transferred to PVDF membranes (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Immobilon</a:t>
            </a:r>
            <a:r>
              <a:rPr lang="en-US" sz="1200" baseline="0" dirty="0" smtClean="0">
                <a:latin typeface="Times New Roman"/>
                <a:cs typeface="Times New Roman"/>
              </a:rPr>
              <a:t>-FL, Millipore) in a semi-dry apparatus, and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immunoblotted</a:t>
            </a:r>
            <a:r>
              <a:rPr lang="en-US" sz="1200" baseline="0" dirty="0" smtClean="0">
                <a:latin typeface="Times New Roman"/>
                <a:cs typeface="Times New Roman"/>
              </a:rPr>
              <a:t> [1]. The relative amounts of different proteins were calculated based on densitometry analysis of each protein band detectable by the ECL signal from WB using either a Fujifilm LAS-1000 camera and Image Gauge 4.1 software or by detecting the band via infrared laser scanning using the LI-COR Odyssey detection system after probing the filter with 1.10,000 dilution of the recommended 2</a:t>
            </a:r>
            <a:r>
              <a:rPr lang="en-US" sz="1200" baseline="30000" dirty="0" smtClean="0">
                <a:latin typeface="Times New Roman"/>
                <a:cs typeface="Times New Roman"/>
              </a:rPr>
              <a:t>nd</a:t>
            </a:r>
            <a:r>
              <a:rPr lang="en-US" sz="1200" baseline="0" dirty="0" smtClean="0">
                <a:latin typeface="Times New Roman"/>
                <a:cs typeface="Times New Roman"/>
              </a:rPr>
              <a:t> antibody, goat anti-rabbit IR-Dye 800CW. The AR was probed with an antibody from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Abcam</a:t>
            </a:r>
            <a:r>
              <a:rPr lang="en-US" sz="1200" baseline="0" dirty="0" smtClean="0">
                <a:latin typeface="Times New Roman"/>
                <a:cs typeface="Times New Roman"/>
              </a:rPr>
              <a:t>, #74272, at 1:1000 dilution. An antibody against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actin</a:t>
            </a:r>
            <a:r>
              <a:rPr lang="en-US" sz="1200" baseline="0" dirty="0" smtClean="0">
                <a:latin typeface="Times New Roman"/>
                <a:cs typeface="Times New Roman"/>
              </a:rPr>
              <a:t> N-terminus (A2103, Sigma) at 1:6000 was used as a loading control for both nuclear- and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cytosol</a:t>
            </a:r>
            <a:r>
              <a:rPr lang="en-US" sz="1200" baseline="0" dirty="0" smtClean="0">
                <a:latin typeface="Times New Roman"/>
                <a:cs typeface="Times New Roman"/>
              </a:rPr>
              <a:t> extracts. </a:t>
            </a:r>
          </a:p>
          <a:p>
            <a:pPr marR="490">
              <a:lnSpc>
                <a:spcPct val="150000"/>
              </a:lnSpc>
            </a:pPr>
            <a:endParaRPr lang="en-US" sz="1200" dirty="0" smtClean="0">
              <a:latin typeface="Times New Roman"/>
              <a:cs typeface="Times New Roman"/>
            </a:endParaRPr>
          </a:p>
          <a:p>
            <a:pPr marR="490">
              <a:lnSpc>
                <a:spcPct val="150000"/>
              </a:lnSpc>
            </a:pPr>
            <a:endParaRPr lang="en-US" sz="1200" baseline="0" dirty="0" smtClean="0">
              <a:latin typeface="Times New Roman"/>
              <a:cs typeface="Times New Roman"/>
            </a:endParaRPr>
          </a:p>
          <a:p>
            <a:pPr marR="490">
              <a:lnSpc>
                <a:spcPct val="150000"/>
              </a:lnSpc>
            </a:pPr>
            <a:endParaRPr lang="en-US" sz="1200" dirty="0" smtClean="0">
              <a:latin typeface="Times New Roman"/>
              <a:cs typeface="Times New Roman"/>
            </a:endParaRPr>
          </a:p>
          <a:p>
            <a:pPr marR="490">
              <a:lnSpc>
                <a:spcPct val="150000"/>
              </a:lnSpc>
            </a:pPr>
            <a:endParaRPr lang="en-US" sz="1200" baseline="0" dirty="0" smtClean="0">
              <a:latin typeface="Times New Roman"/>
              <a:cs typeface="Times New Roman"/>
            </a:endParaRPr>
          </a:p>
          <a:p>
            <a:pPr marR="490">
              <a:lnSpc>
                <a:spcPts val="1640"/>
              </a:lnSpc>
            </a:pPr>
            <a:r>
              <a:rPr lang="en-US" sz="1200" baseline="0" dirty="0" smtClean="0">
                <a:latin typeface="Times New Roman"/>
                <a:cs typeface="Times New Roman"/>
              </a:rPr>
              <a:t>References</a:t>
            </a:r>
          </a:p>
          <a:p>
            <a:pPr marR="490">
              <a:lnSpc>
                <a:spcPts val="1640"/>
              </a:lnSpc>
            </a:pPr>
            <a:r>
              <a:rPr lang="en-US" sz="1200" baseline="0" dirty="0" smtClean="0">
                <a:latin typeface="Times New Roman"/>
                <a:cs typeface="Times New Roman"/>
              </a:rPr>
              <a:t> </a:t>
            </a:r>
          </a:p>
          <a:p>
            <a:pPr marR="490">
              <a:lnSpc>
                <a:spcPts val="1640"/>
              </a:lnSpc>
            </a:pPr>
            <a:r>
              <a:rPr lang="en-US" sz="1200" baseline="0" dirty="0" smtClean="0">
                <a:latin typeface="Times New Roman"/>
                <a:cs typeface="Times New Roman"/>
              </a:rPr>
              <a:t>[1] S. Belikov, P.H.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Holmqvist</a:t>
            </a:r>
            <a:r>
              <a:rPr lang="en-US" sz="1200" baseline="0" dirty="0" smtClean="0">
                <a:latin typeface="Times New Roman"/>
                <a:cs typeface="Times New Roman"/>
              </a:rPr>
              <a:t>, C.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Astrand</a:t>
            </a:r>
            <a:r>
              <a:rPr lang="en-US" sz="1200" baseline="0" dirty="0" smtClean="0">
                <a:latin typeface="Times New Roman"/>
                <a:cs typeface="Times New Roman"/>
              </a:rPr>
              <a:t>, O.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Wrange</a:t>
            </a:r>
            <a:r>
              <a:rPr lang="en-US" sz="1200" baseline="0" dirty="0" smtClean="0">
                <a:latin typeface="Times New Roman"/>
                <a:cs typeface="Times New Roman"/>
              </a:rPr>
              <a:t>, FoxA1 and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glucocorticoid</a:t>
            </a:r>
            <a:r>
              <a:rPr lang="en-US" sz="1200" baseline="0" dirty="0" smtClean="0">
                <a:latin typeface="Times New Roman"/>
                <a:cs typeface="Times New Roman"/>
              </a:rPr>
              <a:t> receptor crosstalk via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histone</a:t>
            </a:r>
            <a:r>
              <a:rPr lang="en-US" sz="1200" baseline="0" dirty="0" smtClean="0">
                <a:latin typeface="Times New Roman"/>
                <a:cs typeface="Times New Roman"/>
              </a:rPr>
              <a:t> H4K16 </a:t>
            </a:r>
            <a:r>
              <a:rPr lang="en-US" sz="1200" baseline="0" dirty="0" err="1" smtClean="0">
                <a:latin typeface="Times New Roman"/>
                <a:cs typeface="Times New Roman"/>
              </a:rPr>
              <a:t>acetylation</a:t>
            </a:r>
            <a:r>
              <a:rPr lang="en-US" sz="1200" baseline="0" dirty="0" smtClean="0">
                <a:latin typeface="Times New Roman"/>
                <a:cs typeface="Times New Roman"/>
              </a:rPr>
              <a:t> at a hormone regulated enhancer, Exp Cell Res, 318 (2012) 61-74.</a:t>
            </a:r>
          </a:p>
          <a:p>
            <a:pPr marR="490">
              <a:lnSpc>
                <a:spcPct val="150000"/>
              </a:lnSpc>
            </a:pPr>
            <a:r>
              <a:rPr lang="en-US" sz="1200" baseline="0" dirty="0" smtClean="0">
                <a:latin typeface="Times New Roman"/>
                <a:cs typeface="Times New Roman"/>
              </a:rPr>
              <a:t> </a:t>
            </a:r>
          </a:p>
          <a:p>
            <a:pPr marR="490">
              <a:lnSpc>
                <a:spcPct val="150000"/>
              </a:lnSpc>
            </a:pPr>
            <a:endParaRPr lang="en-US" sz="1200" baseline="0" dirty="0" smtClean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95151" y="6521122"/>
            <a:ext cx="5547895" cy="31388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40"/>
              </a:lnSpc>
            </a:pPr>
            <a:r>
              <a:rPr lang="en-US" sz="1200" b="1" baseline="0" dirty="0" smtClean="0">
                <a:latin typeface="Times New Roman"/>
              </a:rPr>
              <a:t>Supplementary figure 1</a:t>
            </a:r>
          </a:p>
          <a:p>
            <a:pPr>
              <a:lnSpc>
                <a:spcPts val="1740"/>
              </a:lnSpc>
            </a:pPr>
            <a:r>
              <a:rPr lang="en-US" sz="1200" baseline="0" dirty="0" smtClean="0">
                <a:latin typeface="Times New Roman"/>
              </a:rPr>
              <a:t>(A) The cellular distribution of [</a:t>
            </a:r>
            <a:r>
              <a:rPr lang="en-US" sz="1200" baseline="30000" dirty="0" smtClean="0">
                <a:latin typeface="Times New Roman"/>
              </a:rPr>
              <a:t>3</a:t>
            </a:r>
            <a:r>
              <a:rPr lang="en-US" sz="1200" baseline="0" dirty="0" smtClean="0">
                <a:latin typeface="Times New Roman"/>
              </a:rPr>
              <a:t>H]-R1881 in whole </a:t>
            </a:r>
            <a:r>
              <a:rPr lang="en-US" sz="1200" baseline="0" dirty="0" err="1" smtClean="0">
                <a:latin typeface="Times New Roman"/>
              </a:rPr>
              <a:t>Xenopus</a:t>
            </a:r>
            <a:r>
              <a:rPr lang="en-US" sz="1200" baseline="0" dirty="0" smtClean="0">
                <a:latin typeface="Times New Roman"/>
              </a:rPr>
              <a:t> </a:t>
            </a:r>
            <a:r>
              <a:rPr lang="en-US" sz="1200" baseline="0" dirty="0" err="1" smtClean="0">
                <a:latin typeface="Times New Roman"/>
              </a:rPr>
              <a:t>oocytes</a:t>
            </a:r>
            <a:r>
              <a:rPr lang="en-US" sz="1200" baseline="0" dirty="0" smtClean="0">
                <a:latin typeface="Times New Roman"/>
              </a:rPr>
              <a:t> or isolated </a:t>
            </a:r>
            <a:r>
              <a:rPr lang="en-US" sz="1200" baseline="0" dirty="0" err="1" smtClean="0">
                <a:latin typeface="Times New Roman"/>
              </a:rPr>
              <a:t>oocyte</a:t>
            </a:r>
            <a:r>
              <a:rPr lang="en-US" sz="1200" baseline="0" dirty="0" smtClean="0">
                <a:latin typeface="Times New Roman"/>
              </a:rPr>
              <a:t> nucleus either not injected or injected with 2.8ng of ARQ25 mRNA and then incubated 28h in ~100nM [</a:t>
            </a:r>
            <a:r>
              <a:rPr lang="en-US" sz="1200" baseline="30000" dirty="0" smtClean="0">
                <a:latin typeface="Times New Roman"/>
              </a:rPr>
              <a:t>3</a:t>
            </a:r>
            <a:r>
              <a:rPr lang="en-US" sz="1200" baseline="0" dirty="0" smtClean="0">
                <a:latin typeface="Times New Roman"/>
              </a:rPr>
              <a:t>H]-R1881. At harvest </a:t>
            </a:r>
            <a:r>
              <a:rPr lang="en-US" sz="1200" baseline="0" dirty="0" err="1" smtClean="0">
                <a:latin typeface="Times New Roman"/>
              </a:rPr>
              <a:t>oocytes</a:t>
            </a:r>
            <a:r>
              <a:rPr lang="en-US" sz="1200" baseline="0" dirty="0" smtClean="0">
                <a:latin typeface="Times New Roman"/>
              </a:rPr>
              <a:t> were rinsed in OR2 buffer and extracted in SDS sample buffer followed by radioactivity analysis. The injected </a:t>
            </a:r>
            <a:r>
              <a:rPr lang="en-US" sz="1200" baseline="0" dirty="0" err="1" smtClean="0">
                <a:latin typeface="Times New Roman"/>
              </a:rPr>
              <a:t>oocyte</a:t>
            </a:r>
            <a:r>
              <a:rPr lang="en-US" sz="1200" baseline="0" dirty="0" smtClean="0">
                <a:latin typeface="Times New Roman"/>
              </a:rPr>
              <a:t> nucleus contained 0.021pmol AR protein or 0.52µM [AR]. The average amount of a double sample is shown and the error bars signify average deviation. The inset diagram shows the nuclear hormone content in a smaller scale in order to illustrate the difference in nuclear radioactivity in mRNA AR injected and not injected </a:t>
            </a:r>
            <a:r>
              <a:rPr lang="en-US" sz="1200" baseline="0" dirty="0" err="1" smtClean="0">
                <a:latin typeface="Times New Roman"/>
              </a:rPr>
              <a:t>oocytes</a:t>
            </a:r>
            <a:r>
              <a:rPr lang="en-US" sz="1200" baseline="0" dirty="0" smtClean="0">
                <a:latin typeface="Times New Roman"/>
              </a:rPr>
              <a:t>. (B) WB analysis of </a:t>
            </a:r>
            <a:r>
              <a:rPr lang="en-US" sz="1200" baseline="0" dirty="0" err="1" smtClean="0">
                <a:latin typeface="Times New Roman"/>
              </a:rPr>
              <a:t>Xenopus</a:t>
            </a:r>
            <a:r>
              <a:rPr lang="en-US" sz="1200" baseline="0" dirty="0" smtClean="0">
                <a:latin typeface="Times New Roman"/>
              </a:rPr>
              <a:t> </a:t>
            </a:r>
            <a:r>
              <a:rPr lang="en-US" sz="1200" baseline="0" dirty="0" err="1" smtClean="0">
                <a:latin typeface="Times New Roman"/>
              </a:rPr>
              <a:t>oocyte</a:t>
            </a:r>
            <a:r>
              <a:rPr lang="en-US" sz="1200" baseline="0" dirty="0" smtClean="0">
                <a:latin typeface="Times New Roman"/>
              </a:rPr>
              <a:t> nuclear extracts after injecting mRNA coding for the ARQ25 or ARQ64. Lanes 1 and 2 show the results when the </a:t>
            </a:r>
            <a:r>
              <a:rPr lang="en-US" sz="1200" baseline="0" dirty="0" err="1" smtClean="0">
                <a:latin typeface="Times New Roman"/>
              </a:rPr>
              <a:t>cDNA</a:t>
            </a:r>
            <a:r>
              <a:rPr lang="en-US" sz="1200" baseline="0" dirty="0" smtClean="0">
                <a:latin typeface="Times New Roman"/>
              </a:rPr>
              <a:t> constructs used for mRNA production were propagated in E-coli XL-1 strain, and lanes 3 and 4 show the results after re-amplifying the ARQ64 after transformation using E-coli Sure competent  cells (</a:t>
            </a:r>
            <a:r>
              <a:rPr lang="en-US" sz="1200" baseline="0" dirty="0" err="1" smtClean="0">
                <a:latin typeface="Times New Roman"/>
              </a:rPr>
              <a:t>Stratagene</a:t>
            </a:r>
            <a:r>
              <a:rPr lang="en-US" sz="1200" baseline="0" dirty="0" smtClean="0">
                <a:latin typeface="Times New Roman"/>
              </a:rPr>
              <a:t>). Note that the faster moving band seen in lane 2 is not seen in lane 4.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373559" y="4495580"/>
            <a:ext cx="1888776" cy="1971071"/>
            <a:chOff x="1719206" y="5095823"/>
            <a:chExt cx="1888776" cy="1971071"/>
          </a:xfrm>
        </p:grpSpPr>
        <p:pic>
          <p:nvPicPr>
            <p:cNvPr id="7" name="Picture 6" descr="Untitled-1.tif"/>
            <p:cNvPicPr>
              <a:picLocks noChangeAspect="1"/>
            </p:cNvPicPr>
            <p:nvPr/>
          </p:nvPicPr>
          <p:blipFill>
            <a:blip r:embed="rId2"/>
            <a:srcRect l="-2983" t="1463"/>
            <a:stretch>
              <a:fillRect/>
            </a:stretch>
          </p:blipFill>
          <p:spPr>
            <a:xfrm flipH="1">
              <a:off x="2052675" y="5434903"/>
              <a:ext cx="583159" cy="1412191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115539" y="5655569"/>
              <a:ext cx="492443" cy="12246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-AR</a:t>
              </a:r>
            </a:p>
            <a:p>
              <a:endParaRPr lang="en-US" sz="900" dirty="0" smtClean="0"/>
            </a:p>
            <a:p>
              <a:pPr>
                <a:lnSpc>
                  <a:spcPts val="1400"/>
                </a:lnSpc>
              </a:pPr>
              <a:endParaRPr lang="en-US" sz="1000" dirty="0" smtClean="0"/>
            </a:p>
            <a:p>
              <a:pPr>
                <a:lnSpc>
                  <a:spcPts val="1400"/>
                </a:lnSpc>
              </a:pPr>
              <a:endParaRPr lang="en-US" sz="1000" dirty="0" smtClean="0"/>
            </a:p>
            <a:p>
              <a:pPr>
                <a:lnSpc>
                  <a:spcPts val="1400"/>
                </a:lnSpc>
              </a:pPr>
              <a:endParaRPr lang="en-US" sz="1000" dirty="0" smtClean="0"/>
            </a:p>
            <a:p>
              <a:pPr>
                <a:lnSpc>
                  <a:spcPts val="1400"/>
                </a:lnSpc>
              </a:pPr>
              <a:endParaRPr lang="en-US" sz="1000" dirty="0" smtClean="0"/>
            </a:p>
            <a:p>
              <a:pPr>
                <a:lnSpc>
                  <a:spcPts val="900"/>
                </a:lnSpc>
              </a:pPr>
              <a:r>
                <a:rPr lang="en-US" sz="1000" dirty="0" smtClean="0"/>
                <a:t>-Actin</a:t>
              </a:r>
              <a:endParaRPr lang="en-US" sz="1000" dirty="0"/>
            </a:p>
          </p:txBody>
        </p:sp>
        <p:cxnSp>
          <p:nvCxnSpPr>
            <p:cNvPr id="9" name="Straight Connector 8"/>
            <p:cNvCxnSpPr/>
            <p:nvPr/>
          </p:nvCxnSpPr>
          <p:spPr>
            <a:xfrm rot="5400000">
              <a:off x="1754149" y="6004177"/>
              <a:ext cx="1752176" cy="1588"/>
            </a:xfrm>
            <a:prstGeom prst="line">
              <a:avLst/>
            </a:prstGeom>
            <a:ln w="635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1719206" y="5571128"/>
              <a:ext cx="414653" cy="318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Q64-</a:t>
              </a:r>
            </a:p>
            <a:p>
              <a:pPr>
                <a:lnSpc>
                  <a:spcPts val="620"/>
                </a:lnSpc>
              </a:pPr>
              <a:r>
                <a:rPr lang="en-US" sz="900" dirty="0" smtClean="0"/>
                <a:t>Q25-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052675" y="5095823"/>
              <a:ext cx="1082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XL-1         Sure</a:t>
              </a:r>
              <a:endParaRPr 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74064" y="6820673"/>
              <a:ext cx="11404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1        2        3        4 </a:t>
              </a:r>
              <a:endParaRPr lang="en-US" sz="1000" dirty="0"/>
            </a:p>
          </p:txBody>
        </p:sp>
        <p:pic>
          <p:nvPicPr>
            <p:cNvPr id="13" name="Picture 12" descr="Untitled-2.tif"/>
            <p:cNvPicPr>
              <a:picLocks noChangeAspect="1"/>
            </p:cNvPicPr>
            <p:nvPr/>
          </p:nvPicPr>
          <p:blipFill>
            <a:blip r:embed="rId3"/>
            <a:srcRect r="4042" b="4633"/>
            <a:stretch>
              <a:fillRect/>
            </a:stretch>
          </p:blipFill>
          <p:spPr>
            <a:xfrm>
              <a:off x="2637648" y="5468070"/>
              <a:ext cx="603014" cy="1412193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972466" y="5272676"/>
              <a:ext cx="13131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Q25  Q64    Q25   Q64</a:t>
              </a:r>
              <a:endParaRPr lang="en-US" sz="1000" dirty="0"/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1993637" y="5327709"/>
              <a:ext cx="1178237" cy="1588"/>
            </a:xfrm>
            <a:prstGeom prst="line">
              <a:avLst/>
            </a:prstGeom>
            <a:ln w="635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rot="5400000">
              <a:off x="2287780" y="5434795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rot="5400000">
              <a:off x="2917802" y="5452666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8" name="Chart 17"/>
          <p:cNvGraphicFramePr/>
          <p:nvPr/>
        </p:nvGraphicFramePr>
        <p:xfrm>
          <a:off x="1087772" y="266106"/>
          <a:ext cx="4055533" cy="38946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1271322" y="258546"/>
            <a:ext cx="377853" cy="4524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endParaRPr lang="en-US" dirty="0" smtClean="0"/>
          </a:p>
          <a:p>
            <a:r>
              <a:rPr lang="en-US" dirty="0" smtClean="0"/>
              <a:t>B.</a:t>
            </a:r>
            <a:endParaRPr lang="en-US" dirty="0"/>
          </a:p>
        </p:txBody>
      </p:sp>
      <p:sp>
        <p:nvSpPr>
          <p:cNvPr id="20" name="Rectangle 19"/>
          <p:cNvSpPr/>
          <p:nvPr/>
        </p:nvSpPr>
        <p:spPr>
          <a:xfrm>
            <a:off x="3394015" y="989245"/>
            <a:ext cx="1975500" cy="220346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1" name="Chart 20"/>
          <p:cNvGraphicFramePr/>
          <p:nvPr/>
        </p:nvGraphicFramePr>
        <p:xfrm>
          <a:off x="3331439" y="1168536"/>
          <a:ext cx="1811866" cy="21251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4088946" y="835356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nucl.extr</a:t>
            </a:r>
            <a:endParaRPr lang="en-US" sz="1400" dirty="0"/>
          </a:p>
        </p:txBody>
      </p:sp>
      <p:sp>
        <p:nvSpPr>
          <p:cNvPr id="23" name="Rectangle 22"/>
          <p:cNvSpPr/>
          <p:nvPr/>
        </p:nvSpPr>
        <p:spPr>
          <a:xfrm>
            <a:off x="5003350" y="732801"/>
            <a:ext cx="421866" cy="2561163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oup 58"/>
          <p:cNvGrpSpPr/>
          <p:nvPr/>
        </p:nvGrpSpPr>
        <p:grpSpPr>
          <a:xfrm>
            <a:off x="216694" y="1079871"/>
            <a:ext cx="6376312" cy="7586386"/>
            <a:chOff x="268760" y="337341"/>
            <a:chExt cx="6376312" cy="7586386"/>
          </a:xfrm>
        </p:grpSpPr>
        <p:sp>
          <p:nvSpPr>
            <p:cNvPr id="4" name="TextBox 3"/>
            <p:cNvSpPr txBox="1"/>
            <p:nvPr/>
          </p:nvSpPr>
          <p:spPr>
            <a:xfrm>
              <a:off x="380772" y="337341"/>
              <a:ext cx="3395781" cy="55711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A.                                                              B.</a:t>
              </a:r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r>
                <a:rPr lang="en-US" sz="1600" dirty="0" smtClean="0"/>
                <a:t>                                                             </a:t>
              </a:r>
              <a:r>
                <a:rPr lang="en-US" sz="1100" dirty="0" smtClean="0"/>
                <a:t>   </a:t>
              </a:r>
              <a:r>
                <a:rPr lang="en-US" sz="1600" dirty="0" smtClean="0"/>
                <a:t> D.</a:t>
              </a:r>
            </a:p>
            <a:p>
              <a:pPr>
                <a:lnSpc>
                  <a:spcPts val="2520"/>
                </a:lnSpc>
              </a:pPr>
              <a:r>
                <a:rPr lang="en-US" sz="1600" dirty="0" smtClean="0"/>
                <a:t>C.</a:t>
              </a:r>
              <a:endParaRPr lang="en-US" sz="1600" dirty="0"/>
            </a:p>
          </p:txBody>
        </p:sp>
        <p:graphicFrame>
          <p:nvGraphicFramePr>
            <p:cNvPr id="5" name="Chart 4"/>
            <p:cNvGraphicFramePr/>
            <p:nvPr/>
          </p:nvGraphicFramePr>
          <p:xfrm>
            <a:off x="419438" y="376344"/>
            <a:ext cx="2775880" cy="18694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pic>
          <p:nvPicPr>
            <p:cNvPr id="6" name="Picture 5" descr="Untitled-1.tif"/>
            <p:cNvPicPr>
              <a:picLocks noChangeAspect="1"/>
            </p:cNvPicPr>
            <p:nvPr/>
          </p:nvPicPr>
          <p:blipFill>
            <a:blip r:embed="rId3"/>
            <a:srcRect l="1312" r="9411"/>
            <a:stretch>
              <a:fillRect/>
            </a:stretch>
          </p:blipFill>
          <p:spPr>
            <a:xfrm>
              <a:off x="879475" y="1849536"/>
              <a:ext cx="2159338" cy="271926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595185" y="2115173"/>
              <a:ext cx="2689353" cy="3060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1000" dirty="0" smtClean="0"/>
                <a:t>            </a:t>
              </a:r>
              <a:r>
                <a:rPr lang="en-US" sz="1050" dirty="0" smtClean="0"/>
                <a:t> </a:t>
              </a:r>
              <a:r>
                <a:rPr lang="en-US" sz="1000" dirty="0" smtClean="0">
                  <a:latin typeface="Courier"/>
                  <a:cs typeface="Courier"/>
                </a:rPr>
                <a:t>-</a:t>
              </a:r>
              <a:r>
                <a:rPr lang="en-US" sz="1000" dirty="0" smtClean="0"/>
                <a:t> </a:t>
              </a:r>
            </a:p>
            <a:p>
              <a:pPr>
                <a:lnSpc>
                  <a:spcPts val="800"/>
                </a:lnSpc>
              </a:pPr>
              <a:r>
                <a:rPr lang="en-US" sz="1000" dirty="0" smtClean="0"/>
                <a:t>                           AR Q25                   AR Q64</a:t>
              </a:r>
              <a:endParaRPr lang="en-US" sz="1000" dirty="0"/>
            </a:p>
          </p:txBody>
        </p:sp>
        <p:sp>
          <p:nvSpPr>
            <p:cNvPr id="8" name="Right Triangle 7"/>
            <p:cNvSpPr/>
            <p:nvPr/>
          </p:nvSpPr>
          <p:spPr>
            <a:xfrm flipH="1">
              <a:off x="1232574" y="2134337"/>
              <a:ext cx="860425" cy="114871"/>
            </a:xfrm>
            <a:prstGeom prst="rt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" name="Right Triangle 8"/>
            <p:cNvSpPr/>
            <p:nvPr/>
          </p:nvSpPr>
          <p:spPr>
            <a:xfrm flipH="1">
              <a:off x="2163474" y="2134337"/>
              <a:ext cx="860425" cy="114871"/>
            </a:xfrm>
            <a:prstGeom prst="rt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10" name="Straight Connector 9"/>
            <p:cNvCxnSpPr/>
            <p:nvPr/>
          </p:nvCxnSpPr>
          <p:spPr>
            <a:xfrm rot="5400000">
              <a:off x="849319" y="2258732"/>
              <a:ext cx="276222" cy="3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rot="5400000">
              <a:off x="1977114" y="2257728"/>
              <a:ext cx="276222" cy="3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rot="5400000">
              <a:off x="1062041" y="2258732"/>
              <a:ext cx="276222" cy="3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 rot="16200000">
              <a:off x="702553" y="2148505"/>
              <a:ext cx="43719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 Narrow"/>
                  <a:cs typeface="Arial Narrow"/>
                </a:rPr>
                <a:t>Probe</a:t>
              </a:r>
              <a:endParaRPr lang="en-US" sz="900" dirty="0">
                <a:latin typeface="Arial Narrow"/>
                <a:cs typeface="Arial Narrow"/>
              </a:endParaRPr>
            </a:p>
          </p:txBody>
        </p:sp>
        <p:pic>
          <p:nvPicPr>
            <p:cNvPr id="14" name="Picture 13" descr="Untitled-1.tif"/>
            <p:cNvPicPr>
              <a:picLocks noChangeAspect="1"/>
            </p:cNvPicPr>
            <p:nvPr/>
          </p:nvPicPr>
          <p:blipFill>
            <a:blip r:embed="rId4"/>
            <a:srcRect l="916" t="6193" r="11243" b="3511"/>
            <a:stretch>
              <a:fillRect/>
            </a:stretch>
          </p:blipFill>
          <p:spPr>
            <a:xfrm>
              <a:off x="3867136" y="778775"/>
              <a:ext cx="2497866" cy="3306596"/>
            </a:xfrm>
            <a:prstGeom prst="rect">
              <a:avLst/>
            </a:prstGeom>
            <a:solidFill>
              <a:schemeClr val="tx1"/>
            </a:solidFill>
          </p:spPr>
        </p:pic>
        <p:sp>
          <p:nvSpPr>
            <p:cNvPr id="15" name="Rectangle 14"/>
            <p:cNvSpPr/>
            <p:nvPr/>
          </p:nvSpPr>
          <p:spPr>
            <a:xfrm flipH="1">
              <a:off x="3794319" y="2652124"/>
              <a:ext cx="74604" cy="39159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6" name="Rectangle 15"/>
            <p:cNvSpPr/>
            <p:nvPr/>
          </p:nvSpPr>
          <p:spPr>
            <a:xfrm flipH="1">
              <a:off x="3794318" y="3662224"/>
              <a:ext cx="71402" cy="274990"/>
            </a:xfrm>
            <a:prstGeom prst="rect">
              <a:avLst/>
            </a:prstGeom>
            <a:solidFill>
              <a:schemeClr val="bg1"/>
            </a:solidFill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" name="Rectangle 16"/>
            <p:cNvSpPr/>
            <p:nvPr/>
          </p:nvSpPr>
          <p:spPr>
            <a:xfrm flipH="1">
              <a:off x="3794428" y="3233148"/>
              <a:ext cx="71181" cy="250390"/>
            </a:xfrm>
            <a:prstGeom prst="rect">
              <a:avLst/>
            </a:prstGeom>
            <a:solidFill>
              <a:schemeClr val="bg1"/>
            </a:solidFill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8" name="Rectangle 17"/>
            <p:cNvSpPr/>
            <p:nvPr/>
          </p:nvSpPr>
          <p:spPr>
            <a:xfrm flipH="1">
              <a:off x="3797628" y="2461925"/>
              <a:ext cx="59583" cy="149225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" name="Rectangle 18"/>
            <p:cNvSpPr/>
            <p:nvPr/>
          </p:nvSpPr>
          <p:spPr>
            <a:xfrm flipH="1">
              <a:off x="3789095" y="2139334"/>
              <a:ext cx="71291" cy="131762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0" name="Rectangle 19"/>
            <p:cNvSpPr/>
            <p:nvPr/>
          </p:nvSpPr>
          <p:spPr>
            <a:xfrm flipH="1">
              <a:off x="3794308" y="1749989"/>
              <a:ext cx="71291" cy="8889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Rectangle 20"/>
            <p:cNvSpPr/>
            <p:nvPr/>
          </p:nvSpPr>
          <p:spPr>
            <a:xfrm flipH="1">
              <a:off x="3794308" y="973866"/>
              <a:ext cx="71292" cy="49048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Rectangle 21"/>
            <p:cNvSpPr/>
            <p:nvPr/>
          </p:nvSpPr>
          <p:spPr>
            <a:xfrm flipH="1">
              <a:off x="3794308" y="873688"/>
              <a:ext cx="71292" cy="49048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3" name="Straight Connector 22"/>
            <p:cNvCxnSpPr/>
            <p:nvPr/>
          </p:nvCxnSpPr>
          <p:spPr>
            <a:xfrm rot="16200000" flipH="1">
              <a:off x="2209700" y="2429461"/>
              <a:ext cx="3306596" cy="5224"/>
            </a:xfrm>
            <a:prstGeom prst="line">
              <a:avLst/>
            </a:prstGeom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ight Brace 23"/>
            <p:cNvSpPr/>
            <p:nvPr/>
          </p:nvSpPr>
          <p:spPr>
            <a:xfrm flipH="1">
              <a:off x="3725790" y="873688"/>
              <a:ext cx="68517" cy="1737462"/>
            </a:xfrm>
            <a:prstGeom prst="rightBrace">
              <a:avLst>
                <a:gd name="adj1" fmla="val 53164"/>
                <a:gd name="adj2" fmla="val 50295"/>
              </a:avLst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5" name="Right Brace 24"/>
            <p:cNvSpPr/>
            <p:nvPr/>
          </p:nvSpPr>
          <p:spPr>
            <a:xfrm flipH="1">
              <a:off x="3725793" y="3233148"/>
              <a:ext cx="68515" cy="704065"/>
            </a:xfrm>
            <a:prstGeom prst="rightBrace">
              <a:avLst>
                <a:gd name="adj1" fmla="val 53164"/>
                <a:gd name="adj2" fmla="val 50295"/>
              </a:avLst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2012735" y="2093666"/>
              <a:ext cx="3342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/>
                <a:t>Fox/Oct 1             NF1                               </a:t>
              </a:r>
              <a:r>
                <a:rPr lang="en-US" sz="1000" kern="0" spc="100" dirty="0" smtClean="0"/>
                <a:t>AREs</a:t>
              </a:r>
              <a:endParaRPr lang="en-US" sz="1000" kern="0" spc="100" dirty="0"/>
            </a:p>
          </p:txBody>
        </p:sp>
        <p:sp>
          <p:nvSpPr>
            <p:cNvPr id="27" name="Oval 26"/>
            <p:cNvSpPr/>
            <p:nvPr/>
          </p:nvSpPr>
          <p:spPr>
            <a:xfrm>
              <a:off x="6371351" y="1975182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8" name="Oval 27"/>
            <p:cNvSpPr/>
            <p:nvPr/>
          </p:nvSpPr>
          <p:spPr>
            <a:xfrm>
              <a:off x="6369765" y="2527982"/>
              <a:ext cx="45719" cy="45719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9" name="Oval 28"/>
            <p:cNvSpPr/>
            <p:nvPr/>
          </p:nvSpPr>
          <p:spPr>
            <a:xfrm>
              <a:off x="6369765" y="2177198"/>
              <a:ext cx="45719" cy="45719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0" name="Oval 29"/>
            <p:cNvSpPr/>
            <p:nvPr/>
          </p:nvSpPr>
          <p:spPr>
            <a:xfrm>
              <a:off x="6369765" y="1773496"/>
              <a:ext cx="45719" cy="45719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1" name="Oval 30"/>
            <p:cNvSpPr/>
            <p:nvPr/>
          </p:nvSpPr>
          <p:spPr>
            <a:xfrm>
              <a:off x="6369765" y="3555524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2" name="Oval 31"/>
            <p:cNvSpPr/>
            <p:nvPr/>
          </p:nvSpPr>
          <p:spPr>
            <a:xfrm>
              <a:off x="6369765" y="2123959"/>
              <a:ext cx="45719" cy="4571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33" name="Straight Connector 32"/>
            <p:cNvCxnSpPr/>
            <p:nvPr/>
          </p:nvCxnSpPr>
          <p:spPr>
            <a:xfrm rot="5400000" flipH="1" flipV="1">
              <a:off x="6336629" y="1998793"/>
              <a:ext cx="60716" cy="794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34" name="Chart 33"/>
            <p:cNvGraphicFramePr/>
            <p:nvPr/>
          </p:nvGraphicFramePr>
          <p:xfrm>
            <a:off x="578030" y="1663363"/>
            <a:ext cx="3182325" cy="36703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5" name="Chart 34"/>
            <p:cNvGraphicFramePr/>
            <p:nvPr/>
          </p:nvGraphicFramePr>
          <p:xfrm>
            <a:off x="3443823" y="5633625"/>
            <a:ext cx="3201249" cy="21371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6" name="TextBox 35"/>
            <p:cNvSpPr txBox="1"/>
            <p:nvPr/>
          </p:nvSpPr>
          <p:spPr>
            <a:xfrm>
              <a:off x="3651094" y="5418925"/>
              <a:ext cx="29033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Transcription (A.U.) vs AR-DNA binding (%)</a:t>
              </a:r>
              <a:endParaRPr lang="en-US" sz="12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962341" y="356093"/>
              <a:ext cx="224933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/>
                <a:t>AR-DNA binding as</a:t>
              </a:r>
            </a:p>
            <a:p>
              <a:pPr algn="ctr"/>
              <a:r>
                <a:rPr lang="en-US" sz="1200" b="1" dirty="0" smtClean="0"/>
                <a:t>DMS methylation protection (%)</a:t>
              </a:r>
              <a:endParaRPr lang="en-US" sz="1200" b="1" dirty="0"/>
            </a:p>
          </p:txBody>
        </p:sp>
        <p:graphicFrame>
          <p:nvGraphicFramePr>
            <p:cNvPr id="38" name="Chart 37"/>
            <p:cNvGraphicFramePr/>
            <p:nvPr/>
          </p:nvGraphicFramePr>
          <p:xfrm>
            <a:off x="268760" y="5858139"/>
            <a:ext cx="3553090" cy="20655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39" name="Chart 38"/>
            <p:cNvGraphicFramePr/>
            <p:nvPr/>
          </p:nvGraphicFramePr>
          <p:xfrm>
            <a:off x="3502479" y="4278905"/>
            <a:ext cx="2862523" cy="11373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cxnSp>
          <p:nvCxnSpPr>
            <p:cNvPr id="40" name="Straight Connector 39"/>
            <p:cNvCxnSpPr/>
            <p:nvPr/>
          </p:nvCxnSpPr>
          <p:spPr>
            <a:xfrm rot="5400000">
              <a:off x="4023816" y="4217030"/>
              <a:ext cx="261352" cy="1492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rot="5400000">
              <a:off x="4418777" y="4100984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rot="5400000">
              <a:off x="4703759" y="4101923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 rot="5400000">
              <a:off x="4976805" y="4101497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 rot="5400000">
              <a:off x="5525986" y="4100812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rot="5400000">
              <a:off x="5801643" y="4101923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rot="5400000">
              <a:off x="6079902" y="4101671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3558195" y="4063146"/>
              <a:ext cx="2527406" cy="3060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1000" dirty="0" smtClean="0"/>
                <a:t>AR </a:t>
              </a:r>
              <a:r>
                <a:rPr lang="en-US" sz="1400" dirty="0" smtClean="0"/>
                <a:t> </a:t>
              </a:r>
              <a:r>
                <a:rPr lang="en-US" sz="1000" dirty="0" smtClean="0"/>
                <a:t>    </a:t>
              </a:r>
              <a:r>
                <a:rPr lang="en-US" sz="1000" dirty="0" smtClean="0">
                  <a:latin typeface="Courier"/>
                  <a:cs typeface="Courier"/>
                </a:rPr>
                <a:t>-</a:t>
              </a:r>
              <a:r>
                <a:rPr lang="en-US" sz="1000" dirty="0" smtClean="0"/>
                <a:t> </a:t>
              </a:r>
            </a:p>
            <a:p>
              <a:pPr>
                <a:lnSpc>
                  <a:spcPts val="800"/>
                </a:lnSpc>
              </a:pPr>
              <a:r>
                <a:rPr lang="en-US" sz="1000" dirty="0" smtClean="0"/>
                <a:t>                              AR Q25                      AR Q64</a:t>
              </a:r>
              <a:endParaRPr lang="en-US" sz="1000" dirty="0"/>
            </a:p>
          </p:txBody>
        </p:sp>
        <p:sp>
          <p:nvSpPr>
            <p:cNvPr id="48" name="Right Triangle 47"/>
            <p:cNvSpPr/>
            <p:nvPr/>
          </p:nvSpPr>
          <p:spPr>
            <a:xfrm flipH="1">
              <a:off x="4383294" y="4114690"/>
              <a:ext cx="876172" cy="92055"/>
            </a:xfrm>
            <a:prstGeom prst="rt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9" name="Right Triangle 48"/>
            <p:cNvSpPr/>
            <p:nvPr/>
          </p:nvSpPr>
          <p:spPr>
            <a:xfrm flipH="1">
              <a:off x="5385607" y="4114690"/>
              <a:ext cx="876168" cy="92055"/>
            </a:xfrm>
            <a:prstGeom prst="rtTriangle">
              <a:avLst/>
            </a:prstGeom>
            <a:solidFill>
              <a:schemeClr val="bg1">
                <a:lumMod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0" name="Straight Connector 49"/>
            <p:cNvCxnSpPr/>
            <p:nvPr/>
          </p:nvCxnSpPr>
          <p:spPr>
            <a:xfrm rot="5400000">
              <a:off x="4415793" y="4329584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rot="5400000">
              <a:off x="4700775" y="4330523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rot="5400000">
              <a:off x="4973821" y="4330097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 rot="5400000">
              <a:off x="5523002" y="4329412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rot="5400000">
              <a:off x="5798659" y="4330523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rot="5400000">
              <a:off x="6076918" y="4330271"/>
              <a:ext cx="35527" cy="1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rot="5400000">
              <a:off x="5135066" y="4223380"/>
              <a:ext cx="261352" cy="1492"/>
            </a:xfrm>
            <a:prstGeom prst="line">
              <a:avLst/>
            </a:prstGeom>
            <a:ln w="63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770909" y="5616563"/>
              <a:ext cx="2300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AR-DNA binding (%) vs [AR] (</a:t>
              </a:r>
              <a:r>
                <a:rPr lang="en-US" sz="1200" b="1" dirty="0" smtClean="0">
                  <a:latin typeface="Symbol" charset="2"/>
                  <a:cs typeface="Symbol" charset="2"/>
                </a:rPr>
                <a:t>m</a:t>
              </a:r>
              <a:r>
                <a:rPr lang="en-US" sz="1200" b="1" dirty="0" smtClean="0"/>
                <a:t>M)</a:t>
              </a:r>
              <a:endParaRPr lang="en-US" sz="1200" b="1" dirty="0"/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2923245" y="4476649"/>
              <a:ext cx="103438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/>
                <a:t>DMS </a:t>
              </a:r>
            </a:p>
            <a:p>
              <a:pPr algn="ctr"/>
              <a:r>
                <a:rPr lang="en-US" sz="1000" b="1" dirty="0" err="1" smtClean="0"/>
                <a:t>methylation</a:t>
              </a:r>
              <a:r>
                <a:rPr lang="en-US" sz="1000" b="1" dirty="0" smtClean="0"/>
                <a:t> (%)</a:t>
              </a:r>
              <a:endParaRPr lang="en-US" sz="1000" b="1" dirty="0"/>
            </a:p>
          </p:txBody>
        </p:sp>
      </p:grpSp>
      <p:sp>
        <p:nvSpPr>
          <p:cNvPr id="62" name="TextBox 61"/>
          <p:cNvSpPr txBox="1"/>
          <p:nvPr/>
        </p:nvSpPr>
        <p:spPr>
          <a:xfrm>
            <a:off x="2653066" y="8876650"/>
            <a:ext cx="1785864" cy="3047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40"/>
              </a:lnSpc>
            </a:pPr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sz="1200" b="1" dirty="0" smtClean="0">
                <a:latin typeface="Times New Roman"/>
                <a:cs typeface="Times New Roman"/>
              </a:rPr>
              <a:t>2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9714" y="828842"/>
            <a:ext cx="5559865" cy="37929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40"/>
              </a:lnSpc>
            </a:pPr>
            <a:r>
              <a:rPr lang="en-US" sz="1200" b="1" dirty="0">
                <a:latin typeface="Times New Roman"/>
                <a:cs typeface="Times New Roman"/>
              </a:rPr>
              <a:t>Supplementary figure 2</a:t>
            </a:r>
            <a:endParaRPr lang="en-US" sz="1200" dirty="0">
              <a:latin typeface="Times New Roman"/>
              <a:cs typeface="Times New Roman"/>
            </a:endParaRPr>
          </a:p>
          <a:p>
            <a:pPr>
              <a:lnSpc>
                <a:spcPts val="1740"/>
              </a:lnSpc>
            </a:pPr>
            <a:r>
              <a:rPr lang="en-US" sz="1200" dirty="0">
                <a:latin typeface="Times New Roman"/>
                <a:cs typeface="Times New Roman"/>
              </a:rPr>
              <a:t>Comparison of ARQ25 and ARQ64 function (as in Fig. 2). (A) S1 nuclease protection analysis of transcribed MMTV RNA in </a:t>
            </a:r>
            <a:r>
              <a:rPr lang="en-US" sz="1200" dirty="0" err="1">
                <a:latin typeface="Times New Roman"/>
                <a:cs typeface="Times New Roman"/>
              </a:rPr>
              <a:t>oocytes</a:t>
            </a:r>
            <a:r>
              <a:rPr lang="en-US" sz="1200" dirty="0">
                <a:latin typeface="Times New Roman"/>
                <a:cs typeface="Times New Roman"/>
              </a:rPr>
              <a:t> injected with either 2.1; 3.1; 4.6 or 6.9ng ARQ25 mRNA or 2.7; 4.1; 6.1 or 9.2ng of ARQ64 mRNA and then 3ng </a:t>
            </a:r>
            <a:r>
              <a:rPr lang="en-US" sz="1200" dirty="0" err="1">
                <a:latin typeface="Times New Roman"/>
                <a:cs typeface="Times New Roman"/>
              </a:rPr>
              <a:t>ssDNA</a:t>
            </a:r>
            <a:r>
              <a:rPr lang="en-US" sz="1200" dirty="0">
                <a:latin typeface="Times New Roman"/>
                <a:cs typeface="Times New Roman"/>
              </a:rPr>
              <a:t> pMMTV:M13 and exposed to 100nM R1881. A.U. indicates arbitrary units. The diagram below shows MMTV transcription as a function of nuclear [AR](µM) based on [</a:t>
            </a:r>
            <a:r>
              <a:rPr lang="en-US" sz="1200" baseline="30000" dirty="0">
                <a:latin typeface="Times New Roman"/>
                <a:cs typeface="Times New Roman"/>
              </a:rPr>
              <a:t>3</a:t>
            </a:r>
            <a:r>
              <a:rPr lang="en-US" sz="1200" dirty="0">
                <a:latin typeface="Times New Roman"/>
                <a:cs typeface="Times New Roman"/>
              </a:rPr>
              <a:t>H]-R1881 analysis. (B) Autoradiogram of primer extension from DMS in vivo </a:t>
            </a:r>
            <a:r>
              <a:rPr lang="en-US" sz="1200" dirty="0" err="1">
                <a:latin typeface="Times New Roman"/>
                <a:cs typeface="Times New Roman"/>
              </a:rPr>
              <a:t>footprinting</a:t>
            </a:r>
            <a:r>
              <a:rPr lang="en-US" sz="1200" dirty="0">
                <a:latin typeface="Times New Roman"/>
                <a:cs typeface="Times New Roman"/>
              </a:rPr>
              <a:t> of aliquots of the same </a:t>
            </a:r>
            <a:r>
              <a:rPr lang="en-US" sz="1200" dirty="0" err="1">
                <a:latin typeface="Times New Roman"/>
                <a:cs typeface="Times New Roman"/>
              </a:rPr>
              <a:t>oocytes</a:t>
            </a:r>
            <a:r>
              <a:rPr lang="en-US" sz="1200" dirty="0">
                <a:latin typeface="Times New Roman"/>
                <a:cs typeface="Times New Roman"/>
              </a:rPr>
              <a:t> as in (A). Specific DNA sites for AR (ARE) are indicated on the left side and radioactive bands that are protected in presence of AR, i.e. DMS </a:t>
            </a:r>
            <a:r>
              <a:rPr lang="en-US" sz="1200" dirty="0" err="1">
                <a:latin typeface="Times New Roman"/>
                <a:cs typeface="Times New Roman"/>
              </a:rPr>
              <a:t>methylation</a:t>
            </a:r>
            <a:r>
              <a:rPr lang="en-US" sz="1200" dirty="0">
                <a:latin typeface="Times New Roman"/>
                <a:cs typeface="Times New Roman"/>
              </a:rPr>
              <a:t> protected, are marked on the right with empty circles and reference bands for loading control as filled circles. Quantification of the average value of the protected bands, two lanes per </a:t>
            </a:r>
            <a:r>
              <a:rPr lang="en-US" sz="1200" dirty="0" err="1">
                <a:latin typeface="Times New Roman"/>
                <a:cs typeface="Times New Roman"/>
              </a:rPr>
              <a:t>oocyte</a:t>
            </a:r>
            <a:r>
              <a:rPr lang="en-US" sz="1200" dirty="0">
                <a:latin typeface="Times New Roman"/>
                <a:cs typeface="Times New Roman"/>
              </a:rPr>
              <a:t> pool, are shown as columns below with average deviation of double samples as error bars. (C) AR-DNA binding plotted as a function of </a:t>
            </a:r>
            <a:r>
              <a:rPr lang="en-US" sz="1200" dirty="0" err="1">
                <a:latin typeface="Times New Roman"/>
                <a:cs typeface="Times New Roman"/>
              </a:rPr>
              <a:t>intranuclear</a:t>
            </a:r>
            <a:r>
              <a:rPr lang="en-US" sz="1200" dirty="0">
                <a:latin typeface="Times New Roman"/>
                <a:cs typeface="Times New Roman"/>
              </a:rPr>
              <a:t> [AR] based on quantification of nuclear [</a:t>
            </a:r>
            <a:r>
              <a:rPr lang="en-US" sz="1200" baseline="30000" dirty="0">
                <a:latin typeface="Times New Roman"/>
                <a:cs typeface="Times New Roman"/>
              </a:rPr>
              <a:t>3</a:t>
            </a:r>
            <a:r>
              <a:rPr lang="en-US" sz="1200" dirty="0">
                <a:latin typeface="Times New Roman"/>
                <a:cs typeface="Times New Roman"/>
              </a:rPr>
              <a:t>H]-R1881. (D) Transcription of MMTV RNA analyzed by S1 nuclease protection was plotted as a function of AR-DNA binding activity from DMS </a:t>
            </a:r>
            <a:r>
              <a:rPr lang="en-US" sz="1200" i="1" dirty="0">
                <a:latin typeface="Times New Roman"/>
                <a:cs typeface="Times New Roman"/>
              </a:rPr>
              <a:t>in vivo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footprinting</a:t>
            </a:r>
            <a:r>
              <a:rPr lang="en-US" sz="1200" dirty="0">
                <a:latin typeface="Times New Roman"/>
                <a:cs typeface="Times New Roman"/>
              </a:rPr>
              <a:t>. Curves in the diagrams are calculated by the Curve Expert Pro v.2.2.0 software</a:t>
            </a:r>
            <a:r>
              <a:rPr lang="en-US" sz="1200" dirty="0" smtClean="0">
                <a:latin typeface="Times New Roman"/>
                <a:cs typeface="Times New Roman"/>
              </a:rPr>
              <a:t>.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9715" y="6907720"/>
            <a:ext cx="5399444" cy="183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40"/>
              </a:lnSpc>
            </a:pPr>
            <a:r>
              <a:rPr lang="en-US" sz="1200" b="1" dirty="0">
                <a:latin typeface="Times New Roman"/>
                <a:cs typeface="Times New Roman"/>
              </a:rPr>
              <a:t>Supplementary figure 3</a:t>
            </a:r>
            <a:endParaRPr lang="en-US" sz="1200" dirty="0">
              <a:latin typeface="Times New Roman"/>
              <a:cs typeface="Times New Roman"/>
            </a:endParaRPr>
          </a:p>
          <a:p>
            <a:pPr>
              <a:lnSpc>
                <a:spcPts val="1740"/>
              </a:lnSpc>
            </a:pPr>
            <a:r>
              <a:rPr lang="en-US" sz="1200" dirty="0">
                <a:latin typeface="Times New Roman"/>
                <a:cs typeface="Times New Roman"/>
              </a:rPr>
              <a:t>Comparison of ARQ0, ARQ13 and ARQ25.</a:t>
            </a:r>
            <a:r>
              <a:rPr lang="en-US" sz="1200" b="1" dirty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Oocytes</a:t>
            </a:r>
            <a:r>
              <a:rPr lang="en-US" sz="1200" dirty="0">
                <a:latin typeface="Times New Roman"/>
                <a:cs typeface="Times New Roman"/>
              </a:rPr>
              <a:t> were injected with 3.1; 4.6; 6.9ng ARQ0 mRNA or 4.1; 6.1; 9.2ng ARQ13 mRNA or 2.0; 3.1; 4.6ng ARQ25 mRNA followed by 3ng </a:t>
            </a:r>
            <a:r>
              <a:rPr lang="en-US" sz="1200" dirty="0" err="1">
                <a:latin typeface="Times New Roman"/>
                <a:cs typeface="Times New Roman"/>
              </a:rPr>
              <a:t>ssDNA</a:t>
            </a:r>
            <a:r>
              <a:rPr lang="en-US" sz="1200" dirty="0">
                <a:latin typeface="Times New Roman"/>
                <a:cs typeface="Times New Roman"/>
              </a:rPr>
              <a:t> of pMMTV:M13. (A) Transcription was quantified by S1 nuclease. (B) AR in extracts from isolated nuclei was analyzed by WB. (C) MMTV transcription as a function of nuclear AR concentration in relative terms. Here four groups of </a:t>
            </a:r>
            <a:r>
              <a:rPr lang="en-US" sz="1200" dirty="0" err="1">
                <a:latin typeface="Times New Roman"/>
                <a:cs typeface="Times New Roman"/>
              </a:rPr>
              <a:t>oocytes</a:t>
            </a:r>
            <a:r>
              <a:rPr lang="en-US" sz="1200" dirty="0">
                <a:latin typeface="Times New Roman"/>
                <a:cs typeface="Times New Roman"/>
              </a:rPr>
              <a:t> were analyzed by S1 nuclease protection for each pool of mRNA-injected </a:t>
            </a:r>
            <a:r>
              <a:rPr lang="en-US" sz="1200" dirty="0" err="1">
                <a:latin typeface="Times New Roman"/>
                <a:cs typeface="Times New Roman"/>
              </a:rPr>
              <a:t>oocytes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1548826" y="704083"/>
            <a:ext cx="3226274" cy="5707239"/>
            <a:chOff x="212252" y="194106"/>
            <a:chExt cx="3226274" cy="5707239"/>
          </a:xfrm>
        </p:grpSpPr>
        <p:graphicFrame>
          <p:nvGraphicFramePr>
            <p:cNvPr id="5" name="Chart 4"/>
            <p:cNvGraphicFramePr/>
            <p:nvPr/>
          </p:nvGraphicFramePr>
          <p:xfrm>
            <a:off x="213770" y="3962877"/>
            <a:ext cx="3224756" cy="19384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Chart 5"/>
            <p:cNvGraphicFramePr/>
            <p:nvPr/>
          </p:nvGraphicFramePr>
          <p:xfrm>
            <a:off x="536701" y="432693"/>
            <a:ext cx="2901824" cy="13253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/>
            <a:srcRect l="4684" t="6217" r="4939" b="29678"/>
            <a:stretch>
              <a:fillRect/>
            </a:stretch>
          </p:blipFill>
          <p:spPr>
            <a:xfrm>
              <a:off x="746402" y="1528144"/>
              <a:ext cx="2535393" cy="176643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362354" y="436926"/>
              <a:ext cx="493847" cy="11644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180"/>
                </a:lnSpc>
              </a:pPr>
              <a:r>
                <a:rPr lang="en-US" sz="800" dirty="0" smtClean="0"/>
                <a:t>1200</a:t>
              </a:r>
            </a:p>
            <a:p>
              <a:pPr algn="r">
                <a:lnSpc>
                  <a:spcPts val="1180"/>
                </a:lnSpc>
              </a:pPr>
              <a:r>
                <a:rPr lang="en-US" sz="800" dirty="0" smtClean="0"/>
                <a:t>1000</a:t>
              </a:r>
            </a:p>
            <a:p>
              <a:pPr algn="r">
                <a:lnSpc>
                  <a:spcPts val="1180"/>
                </a:lnSpc>
              </a:pPr>
              <a:r>
                <a:rPr lang="en-US" sz="800" dirty="0" smtClean="0"/>
                <a:t>800</a:t>
              </a:r>
            </a:p>
            <a:p>
              <a:pPr algn="r">
                <a:lnSpc>
                  <a:spcPts val="1180"/>
                </a:lnSpc>
              </a:pPr>
              <a:r>
                <a:rPr lang="en-US" sz="800" dirty="0" smtClean="0"/>
                <a:t>600</a:t>
              </a:r>
            </a:p>
            <a:p>
              <a:pPr algn="r">
                <a:lnSpc>
                  <a:spcPts val="1180"/>
                </a:lnSpc>
              </a:pPr>
              <a:r>
                <a:rPr lang="en-US" sz="800" dirty="0" smtClean="0"/>
                <a:t>400</a:t>
              </a:r>
            </a:p>
            <a:p>
              <a:pPr algn="r">
                <a:lnSpc>
                  <a:spcPts val="1180"/>
                </a:lnSpc>
              </a:pPr>
              <a:r>
                <a:rPr lang="en-US" sz="800" dirty="0" smtClean="0"/>
                <a:t>200</a:t>
              </a:r>
            </a:p>
            <a:p>
              <a:pPr algn="r">
                <a:lnSpc>
                  <a:spcPts val="1180"/>
                </a:lnSpc>
              </a:pPr>
              <a:r>
                <a:rPr lang="en-US" sz="800" dirty="0" smtClean="0"/>
                <a:t>0</a:t>
              </a:r>
              <a:endParaRPr lang="en-US" sz="900" dirty="0"/>
            </a:p>
          </p:txBody>
        </p:sp>
        <p:grpSp>
          <p:nvGrpSpPr>
            <p:cNvPr id="9" name="Group 24"/>
            <p:cNvGrpSpPr/>
            <p:nvPr/>
          </p:nvGrpSpPr>
          <p:grpSpPr>
            <a:xfrm>
              <a:off x="826890" y="1704786"/>
              <a:ext cx="1727724" cy="255481"/>
              <a:chOff x="1362851" y="2233719"/>
              <a:chExt cx="1516876" cy="208650"/>
            </a:xfrm>
          </p:grpSpPr>
          <p:cxnSp>
            <p:nvCxnSpPr>
              <p:cNvPr id="10" name="Straight Connector 18"/>
              <p:cNvCxnSpPr/>
              <p:nvPr/>
            </p:nvCxnSpPr>
            <p:spPr>
              <a:xfrm rot="5400000">
                <a:off x="1259717" y="2337647"/>
                <a:ext cx="207856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9"/>
              <p:cNvCxnSpPr/>
              <p:nvPr/>
            </p:nvCxnSpPr>
            <p:spPr>
              <a:xfrm rot="5400000">
                <a:off x="1473216" y="2336853"/>
                <a:ext cx="207856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rot="5400000">
                <a:off x="2120955" y="2336853"/>
                <a:ext cx="207856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rot="5400000">
                <a:off x="2775005" y="2336853"/>
                <a:ext cx="207856" cy="158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/>
            <p:cNvSpPr txBox="1"/>
            <p:nvPr/>
          </p:nvSpPr>
          <p:spPr>
            <a:xfrm>
              <a:off x="822391" y="1762855"/>
              <a:ext cx="24451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Courier"/>
                  <a:cs typeface="Courier"/>
                </a:rPr>
                <a:t> </a:t>
              </a:r>
              <a:r>
                <a:rPr lang="en-US" sz="1000" dirty="0" smtClean="0"/>
                <a:t>          AR Q0              AR Q13             AR Q25</a:t>
              </a:r>
              <a:endParaRPr lang="en-US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31533" y="1648810"/>
              <a:ext cx="2103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Courier"/>
                  <a:cs typeface="Courier"/>
                </a:rPr>
                <a:t> </a:t>
              </a:r>
              <a:endParaRPr lang="en-US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537307" y="1722324"/>
              <a:ext cx="4371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 Narrow"/>
                  <a:cs typeface="Arial Narrow"/>
                </a:rPr>
                <a:t>Probe</a:t>
              </a:r>
              <a:endParaRPr lang="en-US" sz="900" dirty="0">
                <a:latin typeface="Arial Narrow"/>
                <a:cs typeface="Arial Narrow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 rot="5400000" flipH="1" flipV="1">
              <a:off x="1282762" y="1725586"/>
              <a:ext cx="45719" cy="1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1250000" y="282439"/>
              <a:ext cx="1297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spc="100" dirty="0" smtClean="0"/>
                <a:t>Transcription</a:t>
              </a:r>
              <a:endParaRPr lang="en-US" sz="1200" b="1" spc="1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11542" y="1688648"/>
              <a:ext cx="2979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Courier"/>
                  <a:cs typeface="Courier"/>
                </a:rPr>
                <a:t>-</a:t>
              </a:r>
              <a:endParaRPr lang="en-US" sz="1000" dirty="0">
                <a:latin typeface="Courier"/>
                <a:cs typeface="Courier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-173762" y="925593"/>
              <a:ext cx="12105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kern="0" spc="50" dirty="0" smtClean="0">
                  <a:latin typeface="Arial"/>
                  <a:cs typeface="Arial"/>
                </a:rPr>
                <a:t>MMTV trx. (A. U.)</a:t>
              </a:r>
              <a:endParaRPr lang="en-US" sz="900" b="1" kern="0" spc="50" dirty="0">
                <a:latin typeface="Arial"/>
                <a:cs typeface="Arial"/>
              </a:endParaRP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1109531" y="1738919"/>
              <a:ext cx="2115618" cy="72185"/>
              <a:chOff x="1238924" y="2108937"/>
              <a:chExt cx="2724775" cy="114871"/>
            </a:xfrm>
          </p:grpSpPr>
          <p:sp>
            <p:nvSpPr>
              <p:cNvPr id="22" name="Right Triangle 21"/>
              <p:cNvSpPr/>
              <p:nvPr/>
            </p:nvSpPr>
            <p:spPr>
              <a:xfrm flipH="1">
                <a:off x="1238924" y="2108937"/>
                <a:ext cx="860425" cy="114871"/>
              </a:xfrm>
              <a:prstGeom prst="rtTriangle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3" name="Right Triangle 22"/>
              <p:cNvSpPr/>
              <p:nvPr/>
            </p:nvSpPr>
            <p:spPr>
              <a:xfrm flipH="1">
                <a:off x="2169824" y="2108937"/>
                <a:ext cx="860425" cy="114871"/>
              </a:xfrm>
              <a:prstGeom prst="rtTriangle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4" name="Right Triangle 23"/>
              <p:cNvSpPr/>
              <p:nvPr/>
            </p:nvSpPr>
            <p:spPr>
              <a:xfrm flipH="1">
                <a:off x="3103274" y="2108937"/>
                <a:ext cx="860425" cy="114871"/>
              </a:xfrm>
              <a:prstGeom prst="rtTriangle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cxnSp>
          <p:nvCxnSpPr>
            <p:cNvPr id="25" name="Straight Connector 24"/>
            <p:cNvCxnSpPr/>
            <p:nvPr/>
          </p:nvCxnSpPr>
          <p:spPr>
            <a:xfrm rot="5400000" flipH="1" flipV="1">
              <a:off x="1533587" y="1728761"/>
              <a:ext cx="45719" cy="1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6" name="Group 25"/>
            <p:cNvGrpSpPr/>
            <p:nvPr/>
          </p:nvGrpSpPr>
          <p:grpSpPr>
            <a:xfrm>
              <a:off x="2047875" y="1699551"/>
              <a:ext cx="250826" cy="48894"/>
              <a:chOff x="1467546" y="1855127"/>
              <a:chExt cx="250826" cy="48894"/>
            </a:xfrm>
          </p:grpSpPr>
          <p:cxnSp>
            <p:nvCxnSpPr>
              <p:cNvPr id="27" name="Straight Connector 26"/>
              <p:cNvCxnSpPr/>
              <p:nvPr/>
            </p:nvCxnSpPr>
            <p:spPr>
              <a:xfrm rot="5400000" flipH="1" flipV="1">
                <a:off x="1444687" y="1877986"/>
                <a:ext cx="45719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 rot="5400000" flipH="1" flipV="1">
                <a:off x="1695512" y="1881161"/>
                <a:ext cx="45719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Group 28"/>
            <p:cNvGrpSpPr/>
            <p:nvPr/>
          </p:nvGrpSpPr>
          <p:grpSpPr>
            <a:xfrm>
              <a:off x="2806700" y="1702727"/>
              <a:ext cx="234951" cy="48894"/>
              <a:chOff x="1467546" y="1855127"/>
              <a:chExt cx="234951" cy="48894"/>
            </a:xfrm>
          </p:grpSpPr>
          <p:cxnSp>
            <p:nvCxnSpPr>
              <p:cNvPr id="30" name="Straight Connector 29"/>
              <p:cNvCxnSpPr/>
              <p:nvPr/>
            </p:nvCxnSpPr>
            <p:spPr>
              <a:xfrm rot="5400000" flipH="1" flipV="1">
                <a:off x="1444687" y="1877986"/>
                <a:ext cx="45719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rot="5400000" flipH="1" flipV="1">
                <a:off x="1679637" y="1881161"/>
                <a:ext cx="45719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Group 31"/>
            <p:cNvGrpSpPr/>
            <p:nvPr/>
          </p:nvGrpSpPr>
          <p:grpSpPr>
            <a:xfrm>
              <a:off x="326228" y="2456825"/>
              <a:ext cx="3057161" cy="1298850"/>
              <a:chOff x="326228" y="2418629"/>
              <a:chExt cx="3057161" cy="1298850"/>
            </a:xfrm>
          </p:grpSpPr>
          <p:grpSp>
            <p:nvGrpSpPr>
              <p:cNvPr id="33" name="Group 73"/>
              <p:cNvGrpSpPr/>
              <p:nvPr/>
            </p:nvGrpSpPr>
            <p:grpSpPr>
              <a:xfrm>
                <a:off x="326228" y="2418629"/>
                <a:ext cx="2696785" cy="1298850"/>
                <a:chOff x="3512673" y="2013309"/>
                <a:chExt cx="2696785" cy="1298850"/>
              </a:xfrm>
            </p:grpSpPr>
            <p:pic>
              <p:nvPicPr>
                <p:cNvPr id="35" name="Picture 34"/>
                <p:cNvPicPr>
                  <a:picLocks noChangeAspect="1"/>
                </p:cNvPicPr>
                <p:nvPr/>
              </p:nvPicPr>
              <p:blipFill>
                <a:blip r:embed="rId5"/>
                <a:srcRect r="2237"/>
                <a:stretch>
                  <a:fillRect/>
                </a:stretch>
              </p:blipFill>
              <p:spPr>
                <a:xfrm>
                  <a:off x="3741251" y="2013309"/>
                  <a:ext cx="2429556" cy="995354"/>
                </a:xfrm>
                <a:prstGeom prst="rect">
                  <a:avLst/>
                </a:prstGeom>
              </p:spPr>
            </p:pic>
            <p:grpSp>
              <p:nvGrpSpPr>
                <p:cNvPr id="36" name="Group 24"/>
                <p:cNvGrpSpPr/>
                <p:nvPr/>
              </p:nvGrpSpPr>
              <p:grpSpPr>
                <a:xfrm>
                  <a:off x="4498499" y="3007869"/>
                  <a:ext cx="1402393" cy="255481"/>
                  <a:chOff x="2224089" y="2233719"/>
                  <a:chExt cx="1231067" cy="208650"/>
                </a:xfrm>
              </p:grpSpPr>
              <p:cxnSp>
                <p:nvCxnSpPr>
                  <p:cNvPr id="43" name="Straight Connector 18"/>
                  <p:cNvCxnSpPr/>
                  <p:nvPr/>
                </p:nvCxnSpPr>
                <p:spPr>
                  <a:xfrm rot="5400000">
                    <a:off x="3350434" y="2337647"/>
                    <a:ext cx="207856" cy="1588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 rot="5400000">
                    <a:off x="2120955" y="2336853"/>
                    <a:ext cx="207856" cy="1588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44"/>
                  <p:cNvCxnSpPr/>
                  <p:nvPr/>
                </p:nvCxnSpPr>
                <p:spPr>
                  <a:xfrm rot="5400000">
                    <a:off x="2734126" y="2336853"/>
                    <a:ext cx="207856" cy="1588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7" name="TextBox 36"/>
                <p:cNvSpPr txBox="1"/>
                <p:nvPr/>
              </p:nvSpPr>
              <p:spPr>
                <a:xfrm>
                  <a:off x="3512673" y="3065938"/>
                  <a:ext cx="244511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Courier"/>
                      <a:cs typeface="Courier"/>
                    </a:rPr>
                    <a:t> </a:t>
                  </a:r>
                  <a:r>
                    <a:rPr lang="en-US" sz="1000" dirty="0" smtClean="0"/>
                    <a:t>          AR Q0              AR Q13             AR Q25</a:t>
                  </a:r>
                  <a:endParaRPr lang="en-US" sz="1000" dirty="0"/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5911469" y="2965361"/>
                  <a:ext cx="29798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Courier"/>
                      <a:cs typeface="Courier"/>
                    </a:rPr>
                    <a:t>-</a:t>
                  </a:r>
                  <a:endParaRPr lang="en-US" sz="1000" dirty="0">
                    <a:latin typeface="Courier"/>
                    <a:cs typeface="Courier"/>
                  </a:endParaRPr>
                </a:p>
              </p:txBody>
            </p:sp>
            <p:grpSp>
              <p:nvGrpSpPr>
                <p:cNvPr id="39" name="Group 62"/>
                <p:cNvGrpSpPr/>
                <p:nvPr/>
              </p:nvGrpSpPr>
              <p:grpSpPr>
                <a:xfrm>
                  <a:off x="3799813" y="3042002"/>
                  <a:ext cx="2081755" cy="72185"/>
                  <a:chOff x="1238924" y="2108937"/>
                  <a:chExt cx="2681159" cy="114871"/>
                </a:xfrm>
              </p:grpSpPr>
              <p:sp>
                <p:nvSpPr>
                  <p:cNvPr id="40" name="Right Triangle 39"/>
                  <p:cNvSpPr/>
                  <p:nvPr/>
                </p:nvSpPr>
                <p:spPr>
                  <a:xfrm flipH="1">
                    <a:off x="1238924" y="2108937"/>
                    <a:ext cx="860425" cy="114871"/>
                  </a:xfrm>
                  <a:prstGeom prst="rtTriangl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1" name="Right Triangle 40"/>
                  <p:cNvSpPr/>
                  <p:nvPr/>
                </p:nvSpPr>
                <p:spPr>
                  <a:xfrm flipH="1">
                    <a:off x="2148017" y="2108937"/>
                    <a:ext cx="860424" cy="114871"/>
                  </a:xfrm>
                  <a:prstGeom prst="rtTriangl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42" name="Right Triangle 41"/>
                  <p:cNvSpPr/>
                  <p:nvPr/>
                </p:nvSpPr>
                <p:spPr>
                  <a:xfrm flipH="1">
                    <a:off x="3059659" y="2108937"/>
                    <a:ext cx="860424" cy="114871"/>
                  </a:xfrm>
                  <a:prstGeom prst="rtTriangle">
                    <a:avLst/>
                  </a:prstGeom>
                  <a:solidFill>
                    <a:schemeClr val="bg1">
                      <a:lumMod val="50000"/>
                    </a:schemeClr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</p:grpSp>
          <p:sp>
            <p:nvSpPr>
              <p:cNvPr id="34" name="TextBox 33"/>
              <p:cNvSpPr txBox="1"/>
              <p:nvPr/>
            </p:nvSpPr>
            <p:spPr>
              <a:xfrm>
                <a:off x="2890946" y="2557855"/>
                <a:ext cx="492443" cy="8690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-</a:t>
                </a:r>
                <a:r>
                  <a:rPr lang="en-US" sz="1000" dirty="0" smtClean="0"/>
                  <a:t>AR</a:t>
                </a:r>
              </a:p>
              <a:p>
                <a:endParaRPr lang="en-US" sz="900" dirty="0" smtClean="0"/>
              </a:p>
              <a:p>
                <a:endParaRPr lang="en-US" sz="900" dirty="0" smtClean="0"/>
              </a:p>
              <a:p>
                <a:endParaRPr lang="en-US" sz="900" dirty="0" smtClean="0"/>
              </a:p>
              <a:p>
                <a:pPr>
                  <a:lnSpc>
                    <a:spcPts val="480"/>
                  </a:lnSpc>
                </a:pPr>
                <a:endParaRPr lang="en-US" sz="900" dirty="0" smtClean="0"/>
              </a:p>
              <a:p>
                <a:pPr>
                  <a:lnSpc>
                    <a:spcPts val="1120"/>
                  </a:lnSpc>
                </a:pPr>
                <a:r>
                  <a:rPr lang="en-US" sz="1000" dirty="0" smtClean="0"/>
                  <a:t>-Actin</a:t>
                </a:r>
                <a:endParaRPr lang="en-US" sz="1000" dirty="0"/>
              </a:p>
            </p:txBody>
          </p:sp>
        </p:grpSp>
        <p:sp>
          <p:nvSpPr>
            <p:cNvPr id="46" name="TextBox 45"/>
            <p:cNvSpPr txBox="1"/>
            <p:nvPr/>
          </p:nvSpPr>
          <p:spPr>
            <a:xfrm>
              <a:off x="300272" y="194106"/>
              <a:ext cx="356388" cy="39545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A.                                                              </a:t>
              </a:r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pPr>
                <a:lnSpc>
                  <a:spcPts val="1920"/>
                </a:lnSpc>
              </a:pPr>
              <a:r>
                <a:rPr lang="en-US" sz="1600" dirty="0" smtClean="0"/>
                <a:t>B.</a:t>
              </a:r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endParaRPr lang="en-US" sz="1600" dirty="0" smtClean="0"/>
            </a:p>
            <a:p>
              <a:pPr>
                <a:lnSpc>
                  <a:spcPts val="2520"/>
                </a:lnSpc>
              </a:pPr>
              <a:endParaRPr lang="en-US" sz="1600" dirty="0" smtClean="0"/>
            </a:p>
            <a:p>
              <a:pPr>
                <a:lnSpc>
                  <a:spcPts val="520"/>
                </a:lnSpc>
              </a:pPr>
              <a:r>
                <a:rPr lang="en-US" sz="1600" dirty="0" smtClean="0"/>
                <a:t>C.</a:t>
              </a:r>
              <a:endParaRPr lang="en-US" sz="16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12252" y="2802467"/>
              <a:ext cx="599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spc="100" dirty="0" smtClean="0"/>
                <a:t>WB</a:t>
              </a:r>
              <a:endParaRPr lang="en-US" sz="1200" b="1" spc="1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216117" y="3871609"/>
              <a:ext cx="12973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spc="100" dirty="0" smtClean="0"/>
                <a:t>Transcription</a:t>
              </a:r>
              <a:endParaRPr lang="en-US" sz="1200" b="1" spc="1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1164</Words>
  <Application>Microsoft Macintosh PowerPoint</Application>
  <PresentationFormat>A4 Paper (210x297 mm)</PresentationFormat>
  <Paragraphs>136</Paragraphs>
  <Slides>5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K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ergey Belikov</dc:creator>
  <cp:lastModifiedBy>Örjan Wrange</cp:lastModifiedBy>
  <cp:revision>5</cp:revision>
  <cp:lastPrinted>2015-05-12T11:48:23Z</cp:lastPrinted>
  <dcterms:created xsi:type="dcterms:W3CDTF">2015-07-16T11:38:38Z</dcterms:created>
  <dcterms:modified xsi:type="dcterms:W3CDTF">2015-07-16T11:40:56Z</dcterms:modified>
</cp:coreProperties>
</file>